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91" r:id="rId3"/>
    <p:sldId id="297" r:id="rId4"/>
    <p:sldId id="292" r:id="rId5"/>
    <p:sldId id="293" r:id="rId6"/>
    <p:sldId id="271" r:id="rId7"/>
    <p:sldId id="298" r:id="rId8"/>
    <p:sldId id="296" r:id="rId9"/>
    <p:sldId id="259" r:id="rId10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A36D998-D437-4238-842A-8ACEB7A45806}" v="2" dt="2025-08-19T19:24:19.5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3476" autoAdjust="0"/>
  </p:normalViewPr>
  <p:slideViewPr>
    <p:cSldViewPr snapToGrid="0">
      <p:cViewPr varScale="1">
        <p:scale>
          <a:sx n="53" d="100"/>
          <a:sy n="53" d="100"/>
        </p:scale>
        <p:origin x="115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iam Morales Rogriguez de Lope" userId="1e0ef0d4-dfb9-4f5f-aca7-f709598bc13b" providerId="ADAL" clId="{3A36D998-D437-4238-842A-8ACEB7A45806}"/>
    <pc:docChg chg="modSld">
      <pc:chgData name="Miriam Morales Rogriguez de Lope" userId="1e0ef0d4-dfb9-4f5f-aca7-f709598bc13b" providerId="ADAL" clId="{3A36D998-D437-4238-842A-8ACEB7A45806}" dt="2025-08-19T19:24:19.552" v="1" actId="338"/>
      <pc:docMkLst>
        <pc:docMk/>
      </pc:docMkLst>
      <pc:sldChg chg="addSp delSp modSp">
        <pc:chgData name="Miriam Morales Rogriguez de Lope" userId="1e0ef0d4-dfb9-4f5f-aca7-f709598bc13b" providerId="ADAL" clId="{3A36D998-D437-4238-842A-8ACEB7A45806}" dt="2025-08-19T19:24:19.552" v="1" actId="338"/>
        <pc:sldMkLst>
          <pc:docMk/>
          <pc:sldMk cId="1027273890" sldId="256"/>
        </pc:sldMkLst>
        <pc:spChg chg="mod">
          <ac:chgData name="Miriam Morales Rogriguez de Lope" userId="1e0ef0d4-dfb9-4f5f-aca7-f709598bc13b" providerId="ADAL" clId="{3A36D998-D437-4238-842A-8ACEB7A45806}" dt="2025-08-19T19:23:59.126" v="0" actId="165"/>
          <ac:spMkLst>
            <pc:docMk/>
            <pc:sldMk cId="1027273890" sldId="256"/>
            <ac:spMk id="7" creationId="{DDC1CDA8-F1FF-D92D-B9C9-AFA7264981FB}"/>
          </ac:spMkLst>
        </pc:spChg>
        <pc:spChg chg="mod">
          <ac:chgData name="Miriam Morales Rogriguez de Lope" userId="1e0ef0d4-dfb9-4f5f-aca7-f709598bc13b" providerId="ADAL" clId="{3A36D998-D437-4238-842A-8ACEB7A45806}" dt="2025-08-19T19:23:59.126" v="0" actId="165"/>
          <ac:spMkLst>
            <pc:docMk/>
            <pc:sldMk cId="1027273890" sldId="256"/>
            <ac:spMk id="8" creationId="{D57A3E96-B386-29DD-D433-12768A14A77E}"/>
          </ac:spMkLst>
        </pc:spChg>
        <pc:spChg chg="mod">
          <ac:chgData name="Miriam Morales Rogriguez de Lope" userId="1e0ef0d4-dfb9-4f5f-aca7-f709598bc13b" providerId="ADAL" clId="{3A36D998-D437-4238-842A-8ACEB7A45806}" dt="2025-08-19T19:23:59.126" v="0" actId="165"/>
          <ac:spMkLst>
            <pc:docMk/>
            <pc:sldMk cId="1027273890" sldId="256"/>
            <ac:spMk id="10" creationId="{AB8F37C7-C9DB-5624-FC7C-7195E01DCAC6}"/>
          </ac:spMkLst>
        </pc:spChg>
        <pc:spChg chg="mod">
          <ac:chgData name="Miriam Morales Rogriguez de Lope" userId="1e0ef0d4-dfb9-4f5f-aca7-f709598bc13b" providerId="ADAL" clId="{3A36D998-D437-4238-842A-8ACEB7A45806}" dt="2025-08-19T19:23:59.126" v="0" actId="165"/>
          <ac:spMkLst>
            <pc:docMk/>
            <pc:sldMk cId="1027273890" sldId="256"/>
            <ac:spMk id="14" creationId="{220D3954-3F6D-1FE9-4CE3-8070FA492CF8}"/>
          </ac:spMkLst>
        </pc:spChg>
        <pc:spChg chg="mod">
          <ac:chgData name="Miriam Morales Rogriguez de Lope" userId="1e0ef0d4-dfb9-4f5f-aca7-f709598bc13b" providerId="ADAL" clId="{3A36D998-D437-4238-842A-8ACEB7A45806}" dt="2025-08-19T19:23:59.126" v="0" actId="165"/>
          <ac:spMkLst>
            <pc:docMk/>
            <pc:sldMk cId="1027273890" sldId="256"/>
            <ac:spMk id="20" creationId="{85F9DBC3-9E0B-974C-8469-086904153C96}"/>
          </ac:spMkLst>
        </pc:spChg>
        <pc:spChg chg="mod">
          <ac:chgData name="Miriam Morales Rogriguez de Lope" userId="1e0ef0d4-dfb9-4f5f-aca7-f709598bc13b" providerId="ADAL" clId="{3A36D998-D437-4238-842A-8ACEB7A45806}" dt="2025-08-19T19:24:19.552" v="1" actId="338"/>
          <ac:spMkLst>
            <pc:docMk/>
            <pc:sldMk cId="1027273890" sldId="256"/>
            <ac:spMk id="21" creationId="{B2272727-A934-776C-55A2-7B26AD26678D}"/>
          </ac:spMkLst>
        </pc:spChg>
        <pc:spChg chg="mod topLvl">
          <ac:chgData name="Miriam Morales Rogriguez de Lope" userId="1e0ef0d4-dfb9-4f5f-aca7-f709598bc13b" providerId="ADAL" clId="{3A36D998-D437-4238-842A-8ACEB7A45806}" dt="2025-08-19T19:24:19.552" v="1" actId="338"/>
          <ac:spMkLst>
            <pc:docMk/>
            <pc:sldMk cId="1027273890" sldId="256"/>
            <ac:spMk id="22" creationId="{951AF9FA-2E43-D866-B9F8-E5FB4574BCEC}"/>
          </ac:spMkLst>
        </pc:spChg>
        <pc:spChg chg="mod">
          <ac:chgData name="Miriam Morales Rogriguez de Lope" userId="1e0ef0d4-dfb9-4f5f-aca7-f709598bc13b" providerId="ADAL" clId="{3A36D998-D437-4238-842A-8ACEB7A45806}" dt="2025-08-19T19:23:59.126" v="0" actId="165"/>
          <ac:spMkLst>
            <pc:docMk/>
            <pc:sldMk cId="1027273890" sldId="256"/>
            <ac:spMk id="27" creationId="{5453F462-3985-385E-5056-98934354CF39}"/>
          </ac:spMkLst>
        </pc:spChg>
        <pc:spChg chg="mod">
          <ac:chgData name="Miriam Morales Rogriguez de Lope" userId="1e0ef0d4-dfb9-4f5f-aca7-f709598bc13b" providerId="ADAL" clId="{3A36D998-D437-4238-842A-8ACEB7A45806}" dt="2025-08-19T19:23:59.126" v="0" actId="165"/>
          <ac:spMkLst>
            <pc:docMk/>
            <pc:sldMk cId="1027273890" sldId="256"/>
            <ac:spMk id="28" creationId="{FFAE1ED5-3D2C-668A-0BD4-5B0908C613DE}"/>
          </ac:spMkLst>
        </pc:spChg>
        <pc:spChg chg="mod">
          <ac:chgData name="Miriam Morales Rogriguez de Lope" userId="1e0ef0d4-dfb9-4f5f-aca7-f709598bc13b" providerId="ADAL" clId="{3A36D998-D437-4238-842A-8ACEB7A45806}" dt="2025-08-19T19:23:59.126" v="0" actId="165"/>
          <ac:spMkLst>
            <pc:docMk/>
            <pc:sldMk cId="1027273890" sldId="256"/>
            <ac:spMk id="30" creationId="{A3BED0A0-B90E-EC82-B505-2548282C9C6D}"/>
          </ac:spMkLst>
        </pc:spChg>
        <pc:spChg chg="mod">
          <ac:chgData name="Miriam Morales Rogriguez de Lope" userId="1e0ef0d4-dfb9-4f5f-aca7-f709598bc13b" providerId="ADAL" clId="{3A36D998-D437-4238-842A-8ACEB7A45806}" dt="2025-08-19T19:23:59.126" v="0" actId="165"/>
          <ac:spMkLst>
            <pc:docMk/>
            <pc:sldMk cId="1027273890" sldId="256"/>
            <ac:spMk id="31" creationId="{DC0C567E-1141-1F05-EC37-A499DD7C984E}"/>
          </ac:spMkLst>
        </pc:spChg>
        <pc:spChg chg="mod">
          <ac:chgData name="Miriam Morales Rogriguez de Lope" userId="1e0ef0d4-dfb9-4f5f-aca7-f709598bc13b" providerId="ADAL" clId="{3A36D998-D437-4238-842A-8ACEB7A45806}" dt="2025-08-19T19:24:19.552" v="1" actId="338"/>
          <ac:spMkLst>
            <pc:docMk/>
            <pc:sldMk cId="1027273890" sldId="256"/>
            <ac:spMk id="33" creationId="{05CC4E4F-4BCD-54AF-9537-D13F41DA97A5}"/>
          </ac:spMkLst>
        </pc:spChg>
        <pc:grpChg chg="add mod">
          <ac:chgData name="Miriam Morales Rogriguez de Lope" userId="1e0ef0d4-dfb9-4f5f-aca7-f709598bc13b" providerId="ADAL" clId="{3A36D998-D437-4238-842A-8ACEB7A45806}" dt="2025-08-19T19:24:19.552" v="1" actId="338"/>
          <ac:grpSpMkLst>
            <pc:docMk/>
            <pc:sldMk cId="1027273890" sldId="256"/>
            <ac:grpSpMk id="3" creationId="{7129FA01-25F6-EA40-77A0-B18991141AD2}"/>
          </ac:grpSpMkLst>
        </pc:grpChg>
        <pc:grpChg chg="mod">
          <ac:chgData name="Miriam Morales Rogriguez de Lope" userId="1e0ef0d4-dfb9-4f5f-aca7-f709598bc13b" providerId="ADAL" clId="{3A36D998-D437-4238-842A-8ACEB7A45806}" dt="2025-08-19T19:24:19.552" v="1" actId="338"/>
          <ac:grpSpMkLst>
            <pc:docMk/>
            <pc:sldMk cId="1027273890" sldId="256"/>
            <ac:grpSpMk id="4" creationId="{119AC930-2179-C6D6-ED73-DC67C1E4B142}"/>
          </ac:grpSpMkLst>
        </pc:grpChg>
        <pc:grpChg chg="mod">
          <ac:chgData name="Miriam Morales Rogriguez de Lope" userId="1e0ef0d4-dfb9-4f5f-aca7-f709598bc13b" providerId="ADAL" clId="{3A36D998-D437-4238-842A-8ACEB7A45806}" dt="2025-08-19T19:24:19.552" v="1" actId="338"/>
          <ac:grpSpMkLst>
            <pc:docMk/>
            <pc:sldMk cId="1027273890" sldId="256"/>
            <ac:grpSpMk id="12" creationId="{E7287B23-EBBA-69DA-1F61-FBD5B8C77B26}"/>
          </ac:grpSpMkLst>
        </pc:grpChg>
        <pc:grpChg chg="mod">
          <ac:chgData name="Miriam Morales Rogriguez de Lope" userId="1e0ef0d4-dfb9-4f5f-aca7-f709598bc13b" providerId="ADAL" clId="{3A36D998-D437-4238-842A-8ACEB7A45806}" dt="2025-08-19T19:24:19.552" v="1" actId="338"/>
          <ac:grpSpMkLst>
            <pc:docMk/>
            <pc:sldMk cId="1027273890" sldId="256"/>
            <ac:grpSpMk id="24" creationId="{D35B3257-C5A9-0F51-6296-E08C8D8591E9}"/>
          </ac:grpSpMkLst>
        </pc:grpChg>
      </pc:sldChg>
    </pc:docChg>
  </pc:docChgLst>
  <pc:docChgLst>
    <pc:chgData name="Fernando de la Cuesta Marina" userId="14358d53-51d3-4b14-b097-bd58145af71e" providerId="ADAL" clId="{7D4A0CAB-C00D-4E49-98A9-EBC0107A34D6}"/>
    <pc:docChg chg="undo custSel delSld modSld">
      <pc:chgData name="Fernando de la Cuesta Marina" userId="14358d53-51d3-4b14-b097-bd58145af71e" providerId="ADAL" clId="{7D4A0CAB-C00D-4E49-98A9-EBC0107A34D6}" dt="2025-06-20T09:20:57.752" v="129" actId="1076"/>
      <pc:docMkLst>
        <pc:docMk/>
      </pc:docMkLst>
      <pc:sldChg chg="addSp modSp modNotesTx">
        <pc:chgData name="Fernando de la Cuesta Marina" userId="14358d53-51d3-4b14-b097-bd58145af71e" providerId="ADAL" clId="{7D4A0CAB-C00D-4E49-98A9-EBC0107A34D6}" dt="2025-06-20T09:20:08.004" v="121" actId="164"/>
        <pc:sldMkLst>
          <pc:docMk/>
          <pc:sldMk cId="1027273890" sldId="256"/>
        </pc:sldMkLst>
      </pc:sldChg>
      <pc:sldChg chg="addSp modSp mod modNotesTx">
        <pc:chgData name="Fernando de la Cuesta Marina" userId="14358d53-51d3-4b14-b097-bd58145af71e" providerId="ADAL" clId="{7D4A0CAB-C00D-4E49-98A9-EBC0107A34D6}" dt="2025-06-20T09:20:57.752" v="129" actId="1076"/>
        <pc:sldMkLst>
          <pc:docMk/>
          <pc:sldMk cId="1155592341" sldId="259"/>
        </pc:sldMkLst>
      </pc:sldChg>
      <pc:sldChg chg="addSp modSp modNotesTx">
        <pc:chgData name="Fernando de la Cuesta Marina" userId="14358d53-51d3-4b14-b097-bd58145af71e" providerId="ADAL" clId="{7D4A0CAB-C00D-4E49-98A9-EBC0107A34D6}" dt="2025-06-20T09:20:32.343" v="124" actId="164"/>
        <pc:sldMkLst>
          <pc:docMk/>
          <pc:sldMk cId="1261593939" sldId="271"/>
        </pc:sldMkLst>
      </pc:sldChg>
      <pc:sldChg chg="addSp modSp mod modNotesTx">
        <pc:chgData name="Fernando de la Cuesta Marina" userId="14358d53-51d3-4b14-b097-bd58145af71e" providerId="ADAL" clId="{7D4A0CAB-C00D-4E49-98A9-EBC0107A34D6}" dt="2025-06-20T09:17:53.329" v="120" actId="164"/>
        <pc:sldMkLst>
          <pc:docMk/>
          <pc:sldMk cId="3740583421" sldId="291"/>
        </pc:sldMkLst>
      </pc:sldChg>
      <pc:sldChg chg="addSp modSp">
        <pc:chgData name="Fernando de la Cuesta Marina" userId="14358d53-51d3-4b14-b097-bd58145af71e" providerId="ADAL" clId="{7D4A0CAB-C00D-4E49-98A9-EBC0107A34D6}" dt="2025-06-20T09:20:16.626" v="122" actId="164"/>
        <pc:sldMkLst>
          <pc:docMk/>
          <pc:sldMk cId="2642952875" sldId="292"/>
        </pc:sldMkLst>
      </pc:sldChg>
      <pc:sldChg chg="addSp modSp">
        <pc:chgData name="Fernando de la Cuesta Marina" userId="14358d53-51d3-4b14-b097-bd58145af71e" providerId="ADAL" clId="{7D4A0CAB-C00D-4E49-98A9-EBC0107A34D6}" dt="2025-06-20T09:20:26.592" v="123" actId="164"/>
        <pc:sldMkLst>
          <pc:docMk/>
          <pc:sldMk cId="721430557" sldId="293"/>
        </pc:sldMkLst>
      </pc:sldChg>
      <pc:sldChg chg="delSp del mod">
        <pc:chgData name="Fernando de la Cuesta Marina" userId="14358d53-51d3-4b14-b097-bd58145af71e" providerId="ADAL" clId="{7D4A0CAB-C00D-4E49-98A9-EBC0107A34D6}" dt="2025-06-20T09:16:29.937" v="112" actId="2696"/>
        <pc:sldMkLst>
          <pc:docMk/>
          <pc:sldMk cId="3621740391" sldId="295"/>
        </pc:sldMkLst>
      </pc:sldChg>
      <pc:sldChg chg="addSp modSp modNotesTx">
        <pc:chgData name="Fernando de la Cuesta Marina" userId="14358d53-51d3-4b14-b097-bd58145af71e" providerId="ADAL" clId="{7D4A0CAB-C00D-4E49-98A9-EBC0107A34D6}" dt="2025-06-20T09:20:44.193" v="126" actId="164"/>
        <pc:sldMkLst>
          <pc:docMk/>
          <pc:sldMk cId="3179648836" sldId="296"/>
        </pc:sldMkLst>
      </pc:sldChg>
      <pc:sldChg chg="modNotesTx">
        <pc:chgData name="Fernando de la Cuesta Marina" userId="14358d53-51d3-4b14-b097-bd58145af71e" providerId="ADAL" clId="{7D4A0CAB-C00D-4E49-98A9-EBC0107A34D6}" dt="2025-06-20T09:12:19.782" v="63" actId="20577"/>
        <pc:sldMkLst>
          <pc:docMk/>
          <pc:sldMk cId="3338401071" sldId="297"/>
        </pc:sldMkLst>
      </pc:sldChg>
      <pc:sldChg chg="addSp modSp mod modNotesTx">
        <pc:chgData name="Fernando de la Cuesta Marina" userId="14358d53-51d3-4b14-b097-bd58145af71e" providerId="ADAL" clId="{7D4A0CAB-C00D-4E49-98A9-EBC0107A34D6}" dt="2025-06-20T09:20:38.250" v="125" actId="164"/>
        <pc:sldMkLst>
          <pc:docMk/>
          <pc:sldMk cId="2673119851" sldId="298"/>
        </pc:sldMkLst>
      </pc:sldChg>
    </pc:docChg>
  </pc:docChgLst>
  <pc:docChgLst>
    <pc:chgData name="Miriam Morales Rogriguez de Lope" userId="1e0ef0d4-dfb9-4f5f-aca7-f709598bc13b" providerId="ADAL" clId="{7660D8BE-A6CF-4DBE-9307-E6DAF47C5CF6}"/>
    <pc:docChg chg="undo custSel addSld delSld modSld sldOrd">
      <pc:chgData name="Miriam Morales Rogriguez de Lope" userId="1e0ef0d4-dfb9-4f5f-aca7-f709598bc13b" providerId="ADAL" clId="{7660D8BE-A6CF-4DBE-9307-E6DAF47C5CF6}" dt="2025-06-20T10:38:36.233" v="2163" actId="20577"/>
      <pc:docMkLst>
        <pc:docMk/>
      </pc:docMkLst>
      <pc:sldChg chg="addSp delSp modSp new mod modNotesTx">
        <pc:chgData name="Miriam Morales Rogriguez de Lope" userId="1e0ef0d4-dfb9-4f5f-aca7-f709598bc13b" providerId="ADAL" clId="{7660D8BE-A6CF-4DBE-9307-E6DAF47C5CF6}" dt="2025-06-19T11:55:32.531" v="1877" actId="114"/>
        <pc:sldMkLst>
          <pc:docMk/>
          <pc:sldMk cId="1027273890" sldId="256"/>
        </pc:sldMkLst>
      </pc:sldChg>
      <pc:sldChg chg="delSp new del mod">
        <pc:chgData name="Miriam Morales Rogriguez de Lope" userId="1e0ef0d4-dfb9-4f5f-aca7-f709598bc13b" providerId="ADAL" clId="{7660D8BE-A6CF-4DBE-9307-E6DAF47C5CF6}" dt="2025-06-16T12:33:37.527" v="39" actId="2696"/>
        <pc:sldMkLst>
          <pc:docMk/>
          <pc:sldMk cId="2346478115" sldId="257"/>
        </pc:sldMkLst>
      </pc:sldChg>
      <pc:sldChg chg="addSp delSp modSp add mod modNotesTx">
        <pc:chgData name="Miriam Morales Rogriguez de Lope" userId="1e0ef0d4-dfb9-4f5f-aca7-f709598bc13b" providerId="ADAL" clId="{7660D8BE-A6CF-4DBE-9307-E6DAF47C5CF6}" dt="2025-06-20T10:38:36.233" v="2163" actId="20577"/>
        <pc:sldMkLst>
          <pc:docMk/>
          <pc:sldMk cId="1155592341" sldId="259"/>
        </pc:sldMkLst>
      </pc:sldChg>
      <pc:sldChg chg="addSp modSp add mod ord modNotesTx">
        <pc:chgData name="Miriam Morales Rogriguez de Lope" userId="1e0ef0d4-dfb9-4f5f-aca7-f709598bc13b" providerId="ADAL" clId="{7660D8BE-A6CF-4DBE-9307-E6DAF47C5CF6}" dt="2025-06-19T11:56:42.744" v="1907" actId="20577"/>
        <pc:sldMkLst>
          <pc:docMk/>
          <pc:sldMk cId="1261593939" sldId="271"/>
        </pc:sldMkLst>
      </pc:sldChg>
      <pc:sldChg chg="addSp delSp modSp add mod ord modNotesTx">
        <pc:chgData name="Miriam Morales Rogriguez de Lope" userId="1e0ef0d4-dfb9-4f5f-aca7-f709598bc13b" providerId="ADAL" clId="{7660D8BE-A6CF-4DBE-9307-E6DAF47C5CF6}" dt="2025-06-19T15:34:31.576" v="2158" actId="20577"/>
        <pc:sldMkLst>
          <pc:docMk/>
          <pc:sldMk cId="3740583421" sldId="291"/>
        </pc:sldMkLst>
      </pc:sldChg>
      <pc:sldChg chg="addSp modSp add mod modNotesTx">
        <pc:chgData name="Miriam Morales Rogriguez de Lope" userId="1e0ef0d4-dfb9-4f5f-aca7-f709598bc13b" providerId="ADAL" clId="{7660D8BE-A6CF-4DBE-9307-E6DAF47C5CF6}" dt="2025-06-19T11:55:45.306" v="1881" actId="114"/>
        <pc:sldMkLst>
          <pc:docMk/>
          <pc:sldMk cId="2642952875" sldId="292"/>
        </pc:sldMkLst>
      </pc:sldChg>
      <pc:sldChg chg="addSp delSp modSp add mod ord modNotesTx">
        <pc:chgData name="Miriam Morales Rogriguez de Lope" userId="1e0ef0d4-dfb9-4f5f-aca7-f709598bc13b" providerId="ADAL" clId="{7660D8BE-A6CF-4DBE-9307-E6DAF47C5CF6}" dt="2025-06-19T11:56:15.334" v="1902" actId="20577"/>
        <pc:sldMkLst>
          <pc:docMk/>
          <pc:sldMk cId="721430557" sldId="293"/>
        </pc:sldMkLst>
      </pc:sldChg>
      <pc:sldChg chg="addSp delSp modSp add del mod ord modNotesTx">
        <pc:chgData name="Miriam Morales Rogriguez de Lope" userId="1e0ef0d4-dfb9-4f5f-aca7-f709598bc13b" providerId="ADAL" clId="{7660D8BE-A6CF-4DBE-9307-E6DAF47C5CF6}" dt="2025-06-16T12:47:08.340" v="167" actId="2696"/>
        <pc:sldMkLst>
          <pc:docMk/>
          <pc:sldMk cId="262596336" sldId="294"/>
        </pc:sldMkLst>
      </pc:sldChg>
      <pc:sldChg chg="addSp delSp modSp add mod ord modNotesTx">
        <pc:chgData name="Miriam Morales Rogriguez de Lope" userId="1e0ef0d4-dfb9-4f5f-aca7-f709598bc13b" providerId="ADAL" clId="{7660D8BE-A6CF-4DBE-9307-E6DAF47C5CF6}" dt="2025-06-19T11:57:51.621" v="1964"/>
        <pc:sldMkLst>
          <pc:docMk/>
          <pc:sldMk cId="3621740391" sldId="295"/>
        </pc:sldMkLst>
      </pc:sldChg>
      <pc:sldChg chg="addSp delSp modSp add mod ord modNotesTx">
        <pc:chgData name="Miriam Morales Rogriguez de Lope" userId="1e0ef0d4-dfb9-4f5f-aca7-f709598bc13b" providerId="ADAL" clId="{7660D8BE-A6CF-4DBE-9307-E6DAF47C5CF6}" dt="2025-06-20T10:38:31.819" v="2160" actId="20577"/>
        <pc:sldMkLst>
          <pc:docMk/>
          <pc:sldMk cId="3179648836" sldId="296"/>
        </pc:sldMkLst>
      </pc:sldChg>
      <pc:sldChg chg="addSp delSp modSp add mod ord modNotesTx">
        <pc:chgData name="Miriam Morales Rogriguez de Lope" userId="1e0ef0d4-dfb9-4f5f-aca7-f709598bc13b" providerId="ADAL" clId="{7660D8BE-A6CF-4DBE-9307-E6DAF47C5CF6}" dt="2025-06-19T11:55:40.527" v="1879" actId="114"/>
        <pc:sldMkLst>
          <pc:docMk/>
          <pc:sldMk cId="3338401071" sldId="297"/>
        </pc:sldMkLst>
      </pc:sldChg>
      <pc:sldChg chg="new del">
        <pc:chgData name="Miriam Morales Rogriguez de Lope" userId="1e0ef0d4-dfb9-4f5f-aca7-f709598bc13b" providerId="ADAL" clId="{7660D8BE-A6CF-4DBE-9307-E6DAF47C5CF6}" dt="2025-06-18T08:31:47.332" v="1549" actId="2696"/>
        <pc:sldMkLst>
          <pc:docMk/>
          <pc:sldMk cId="1902265236" sldId="298"/>
        </pc:sldMkLst>
      </pc:sldChg>
      <pc:sldChg chg="addSp delSp modSp add mod modNotesTx">
        <pc:chgData name="Miriam Morales Rogriguez de Lope" userId="1e0ef0d4-dfb9-4f5f-aca7-f709598bc13b" providerId="ADAL" clId="{7660D8BE-A6CF-4DBE-9307-E6DAF47C5CF6}" dt="2025-06-19T11:57:05.282" v="1938" actId="20577"/>
        <pc:sldMkLst>
          <pc:docMk/>
          <pc:sldMk cId="2673119851" sldId="29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B5F15C-BCFA-4CC6-A69E-566042D3378E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37DD2D-9E0D-4A9E-B8A9-21DB5DA9EB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60281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i="1" dirty="0"/>
              <a:t>Supplementary Figure 1. </a:t>
            </a:r>
            <a:r>
              <a:rPr lang="en-US" i="1" dirty="0"/>
              <a:t>Venn diagrams. </a:t>
            </a:r>
            <a:r>
              <a:rPr lang="en-US" b="1" i="1" dirty="0"/>
              <a:t>A)</a:t>
            </a:r>
            <a:r>
              <a:rPr lang="en-US" i="1" dirty="0"/>
              <a:t> Venn diagram of three biological replicates of proteins obtained after EV lysis. </a:t>
            </a:r>
            <a:r>
              <a:rPr lang="en-US" b="1" i="1" dirty="0"/>
              <a:t>B) </a:t>
            </a:r>
            <a:r>
              <a:rPr lang="en-US" i="1" dirty="0"/>
              <a:t>Venn diagram comparing proteins obtained after EV lysis (117 proteins) and after the protein solubilization step (1145). </a:t>
            </a:r>
            <a:r>
              <a:rPr lang="en-US" b="1" i="1" dirty="0"/>
              <a:t>C) </a:t>
            </a:r>
            <a:r>
              <a:rPr lang="en-US" sz="1200" b="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enn diagram of t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ree biological replicates of the fractions containing more than 0,05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g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L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total soluble protein after size-exclusion chromatography (SEC) of Arab-EVs. </a:t>
            </a:r>
            <a:endParaRPr lang="en-US" b="1" i="1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37DD2D-9E0D-4A9E-B8A9-21DB5DA9EB6D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47101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i="1" dirty="0"/>
              <a:t>Supplementary Figure 2. </a:t>
            </a:r>
            <a:r>
              <a:rPr lang="en-US" sz="1200" b="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i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cipal component analysis (PCAs). 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)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CA of </a:t>
            </a:r>
            <a:r>
              <a:rPr lang="en-US" i="1" dirty="0"/>
              <a:t>three biological replicates from proteins found in Arath-EVs after lysis versus Arath-EVs after protein solubilization. </a:t>
            </a:r>
            <a:r>
              <a:rPr lang="en-US" b="1" i="1" dirty="0"/>
              <a:t>B)</a:t>
            </a:r>
            <a:r>
              <a:rPr lang="en-US" i="1" dirty="0"/>
              <a:t> PCA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</a:t>
            </a:r>
            <a:r>
              <a:rPr lang="en-US" i="1" dirty="0"/>
              <a:t>three biological replicates from proteins found in fractions without EVs (after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omatography of Arab-EVs) versus of proteins found </a:t>
            </a:r>
            <a:r>
              <a:rPr lang="en-US" i="1" dirty="0"/>
              <a:t>in Arath-EVs after protein solubilization.</a:t>
            </a:r>
            <a:endParaRPr lang="es-ES" i="1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0AAAA1-4255-40DB-A2A9-1A4948DC6B6A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664588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038446D-4AE2-DE74-B36F-BD1C12C168B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D847241F-C618-C4C0-C4E7-0613AB30C4B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4189FBD8-8F7F-F1D0-8A93-074E42C7F3B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i="1" dirty="0"/>
              <a:t>Supplementary Figure 3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ular Component enrichment analysis of the 899 proteins identified in 3 biological replicates from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aol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EVs. </a:t>
            </a:r>
            <a:endParaRPr lang="en-US" b="1" i="1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553A94A-B05A-9CC4-C1CD-D73C42D7C39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37DD2D-9E0D-4A9E-B8A9-21DB5DA9EB6D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040376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i="1" noProof="0" dirty="0"/>
              <a:t>Supplementary</a:t>
            </a:r>
            <a:r>
              <a:rPr lang="es-ES" b="1" i="1" dirty="0"/>
              <a:t> Figure 4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olutionary distance representation of </a:t>
            </a:r>
            <a:r>
              <a:rPr lang="es-ES" i="1" dirty="0" err="1"/>
              <a:t>well-defined</a:t>
            </a:r>
            <a:r>
              <a:rPr lang="es-ES" i="1" dirty="0"/>
              <a:t> </a:t>
            </a:r>
            <a:r>
              <a:rPr lang="en-US" b="0" i="1" dirty="0">
                <a:solidFill>
                  <a:srgbClr val="000000"/>
                </a:solidFill>
                <a:effectLst/>
                <a:latin typeface="WordVisi_MSFontService"/>
              </a:rPr>
              <a:t>EV markers in animals: </a:t>
            </a:r>
            <a:r>
              <a:rPr lang="en-US" b="1" i="1" dirty="0">
                <a:solidFill>
                  <a:srgbClr val="000000"/>
                </a:solidFill>
                <a:effectLst/>
                <a:latin typeface="WordVisi_MSFontService"/>
              </a:rPr>
              <a:t>A)</a:t>
            </a:r>
            <a:r>
              <a:rPr lang="en-US" b="0" i="1" dirty="0">
                <a:solidFill>
                  <a:srgbClr val="000000"/>
                </a:solidFill>
                <a:effectLst/>
                <a:latin typeface="WordVisi_MSFontService"/>
              </a:rPr>
              <a:t> CD9 </a:t>
            </a:r>
            <a:r>
              <a:rPr lang="en-US" b="1" i="1" dirty="0">
                <a:solidFill>
                  <a:srgbClr val="000000"/>
                </a:solidFill>
                <a:effectLst/>
                <a:latin typeface="WordVisi_MSFontService"/>
              </a:rPr>
              <a:t>B)</a:t>
            </a:r>
            <a:r>
              <a:rPr lang="en-US" b="0" i="1" dirty="0">
                <a:solidFill>
                  <a:srgbClr val="000000"/>
                </a:solidFill>
                <a:effectLst/>
                <a:latin typeface="WordVisi_MSFontService"/>
              </a:rPr>
              <a:t> CD81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scale bar is set at 0.05. Phylogenetic trees were generated using MEGA11</a:t>
            </a:r>
            <a:r>
              <a:rPr lang="en-US" sz="1200" i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1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ES" sz="1200" i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8FC3BC-34CA-4372-A5D7-4679FD5FFC48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230310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CE239D1-6F63-E8E0-F1A9-E71A36D454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1C560396-F16F-18EC-9628-482F29F9B27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AFD4B78E-2797-67C8-964D-3B0BEB13D6E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i="1" dirty="0"/>
              <a:t>Supplementary Figure 5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olutionary distance representation </a:t>
            </a:r>
            <a:r>
              <a:rPr lang="en-US" i="1" dirty="0"/>
              <a:t>of: </a:t>
            </a:r>
            <a:r>
              <a:rPr lang="en-US" b="1" i="1" dirty="0"/>
              <a:t>A) </a:t>
            </a:r>
            <a:r>
              <a:rPr lang="en-US" i="1" dirty="0"/>
              <a:t>aquaporin1-2 (</a:t>
            </a:r>
            <a:r>
              <a:rPr lang="es-ES" i="1" dirty="0"/>
              <a:t>PIP12) </a:t>
            </a:r>
            <a:r>
              <a:rPr lang="es-ES" b="1" i="1" dirty="0"/>
              <a:t>B)</a:t>
            </a:r>
            <a:r>
              <a:rPr lang="es-ES" i="1" dirty="0"/>
              <a:t>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athrin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eavy chain 2 (</a:t>
            </a:r>
            <a:r>
              <a:rPr lang="es-ES" i="1" dirty="0"/>
              <a:t>CLAH2). </a:t>
            </a:r>
            <a:r>
              <a:rPr lang="en-US" b="0" i="1" dirty="0">
                <a:solidFill>
                  <a:srgbClr val="000000"/>
                </a:solidFill>
                <a:effectLst/>
                <a:latin typeface="WordVisi_MSFontService"/>
              </a:rPr>
              <a:t>T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 scale bar is set at 0.05. Phylogenetic trees were generated using MEGA11</a:t>
            </a:r>
            <a:r>
              <a:rPr lang="en-US" sz="1200" i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1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ES" sz="1200" i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i="1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B5522CE1-02B7-B6E4-5E37-EFEA28702BE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8FC3BC-34CA-4372-A5D7-4679FD5FFC48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726589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6. </a:t>
            </a:r>
            <a:r>
              <a:rPr lang="en-US" sz="18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olutionary distance representation of </a:t>
            </a:r>
            <a:r>
              <a:rPr lang="en-US" sz="1800" i="1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yntaxins</a:t>
            </a:r>
            <a:r>
              <a:rPr lang="en-US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family members, proposed as </a:t>
            </a:r>
            <a:r>
              <a:rPr lang="en-GB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otential PEV markers expressed across both plant and animal taxa: </a:t>
            </a:r>
            <a:r>
              <a:rPr lang="en-US" sz="1800" b="1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) </a:t>
            </a:r>
            <a:r>
              <a:rPr lang="en-US" sz="1800" i="1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yntaxin</a:t>
            </a:r>
            <a:r>
              <a:rPr lang="en-US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121 (SY121) and </a:t>
            </a:r>
            <a:r>
              <a:rPr lang="en-US" sz="1800" b="1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)</a:t>
            </a:r>
            <a:r>
              <a:rPr lang="en-US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800" i="1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yntaxin</a:t>
            </a:r>
            <a:r>
              <a:rPr lang="en-US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132 (SY132). </a:t>
            </a:r>
            <a:r>
              <a:rPr lang="en-US" sz="1800" b="0" i="1" dirty="0">
                <a:solidFill>
                  <a:srgbClr val="000000"/>
                </a:solidFill>
                <a:effectLst/>
                <a:latin typeface="WordVisi_MSFontService"/>
              </a:rPr>
              <a:t>T</a:t>
            </a:r>
            <a:r>
              <a:rPr lang="en-US" sz="18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 scale bar is set at 0.05. Phylogenetic trees were generated using MEGA11</a:t>
            </a:r>
            <a:r>
              <a:rPr lang="en-US" sz="1800" i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1</a:t>
            </a:r>
            <a:r>
              <a:rPr lang="en-US" sz="18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ES" sz="1800" i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sz="1800" i="1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8FC3BC-34CA-4372-A5D7-4679FD5FFC48}" type="slidenum">
              <a:rPr lang="es-ES" smtClean="0"/>
              <a:t>6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509788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DC2BB41-E478-399F-15BD-DAFAB0FA97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975E3E7B-36EB-AB42-795C-4E0F98DD681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C2DD4116-B523-2CED-D0D2-B1657DD192F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i="1" dirty="0"/>
              <a:t>Supplementary Figure 7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olutionary distance representation of 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)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lreticulin-1 (CALR1) and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)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-type proton ATPase catalytic subunit A (VATA). . </a:t>
            </a:r>
            <a:r>
              <a:rPr lang="en-US" sz="1200" b="0" i="1" dirty="0">
                <a:solidFill>
                  <a:srgbClr val="000000"/>
                </a:solidFill>
                <a:effectLst/>
                <a:latin typeface="WordVisi_MSFontService"/>
              </a:rPr>
              <a:t>T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 scale bar is set at 0.05. Phylogenetic trees were generated using MEGA11</a:t>
            </a:r>
            <a:r>
              <a:rPr lang="en-US" sz="1200" i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1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ES" sz="1200" i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sz="1200" i="1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i="1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68B5229-26F1-F919-6521-9F7B5773378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8FC3BC-34CA-4372-A5D7-4679FD5FFC48}" type="slidenum">
              <a:rPr lang="es-ES" smtClean="0"/>
              <a:t>7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718311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FAD33F0-89A9-D29E-91CA-D3484AAE1F4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AAB23206-32C0-91BC-7F0B-BAA496EDAF8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8E34F9DC-06A9-C302-1107-9EBEA92878D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i="1" dirty="0"/>
              <a:t>Supplementary Figure 8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olutionary distance representation of </a:t>
            </a:r>
            <a:r>
              <a:rPr lang="en-US" i="1" dirty="0"/>
              <a:t>two plant specific proteins, </a:t>
            </a:r>
            <a:r>
              <a:rPr lang="en-US" sz="12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roposed as </a:t>
            </a:r>
            <a:r>
              <a:rPr lang="en-GB" sz="12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otential PEV marker expressed </a:t>
            </a:r>
            <a:r>
              <a:rPr lang="en-US" i="1" dirty="0"/>
              <a:t>: </a:t>
            </a:r>
            <a:r>
              <a:rPr lang="en-US" b="1" i="1" dirty="0"/>
              <a:t>A)</a:t>
            </a:r>
            <a:r>
              <a:rPr lang="en-US" i="1" dirty="0"/>
              <a:t> FLA13, </a:t>
            </a:r>
            <a:r>
              <a:rPr lang="en-US" b="1" i="1" dirty="0"/>
              <a:t>B)</a:t>
            </a:r>
            <a:r>
              <a:rPr lang="en-US" i="1" dirty="0"/>
              <a:t> FLA10. </a:t>
            </a:r>
            <a:r>
              <a:rPr lang="en-US" sz="1200" b="0" i="1" dirty="0">
                <a:solidFill>
                  <a:srgbClr val="000000"/>
                </a:solidFill>
                <a:effectLst/>
                <a:latin typeface="WordVisi_MSFontService"/>
              </a:rPr>
              <a:t>T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 scale bar is set at 0.05. Phylogenetic trees were generated using MEGA11</a:t>
            </a:r>
            <a:r>
              <a:rPr lang="en-US" sz="1200" i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1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ES" i="1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2E3EC69-2A52-0E68-2A07-6D8E8D4B59A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8FC3BC-34CA-4372-A5D7-4679FD5FFC48}" type="slidenum">
              <a:rPr lang="es-ES" smtClean="0"/>
              <a:t>8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754709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i="1" dirty="0"/>
              <a:t>Supplementary Figure 9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olutionary distance representation </a:t>
            </a:r>
            <a:r>
              <a:rPr lang="en-US" i="1" dirty="0"/>
              <a:t>of a plant specific protein, </a:t>
            </a:r>
            <a:r>
              <a:rPr lang="en-US" i="1" dirty="0" err="1"/>
              <a:t>germin</a:t>
            </a:r>
            <a:r>
              <a:rPr lang="en-US" i="1" dirty="0"/>
              <a:t>-like protein: GL33. </a:t>
            </a:r>
            <a:r>
              <a:rPr lang="en-US" sz="1200" b="0" i="1" dirty="0">
                <a:solidFill>
                  <a:srgbClr val="000000"/>
                </a:solidFill>
                <a:effectLst/>
                <a:latin typeface="WordVisi_MSFontService"/>
              </a:rPr>
              <a:t>T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 scale bar is set at 0.05. Phylogenetic trees were generated using MEGA11</a:t>
            </a:r>
            <a:r>
              <a:rPr lang="en-US" sz="1200" i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1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8FC3BC-34CA-4372-A5D7-4679FD5FFC48}" type="slidenum">
              <a:rPr lang="es-ES" smtClean="0"/>
              <a:t>9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03032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2CA7541-BBD5-062C-F5AD-2EF5BCDFC5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63C39D0-F0D8-D261-210F-D9FFDB6AB4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715F298-BAF8-A267-0D6D-6B51BA709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F778BE1-79E9-973F-C320-012DC5F00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598777-C57C-3C6A-DE44-1D5BB0387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9386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48F22A0-3D7F-C181-8AD2-9C07FBE2BE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455B079-B48A-6E64-9C96-B805D1CAED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DB73487-839A-2F43-80BB-57173D86D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3D1358E-9376-08F5-1716-08C5C0237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25D978E-BD5E-0CB9-9779-1E7D8B831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69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ABC67EC-BEA5-B83B-12A2-8839975D65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69C15B5-A30B-9E61-1F88-7EB1135B49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6E8D643-C8BD-C97B-0631-44A4F44C5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1DCEF7A-F082-607E-6371-36A9BF853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3AC876B-342B-5D32-6810-463CD42EC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4074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8691545-95AE-EC22-7F59-65143A14F7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8937FB0-2BBA-0977-8609-C6AC24A716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C1B4110-7A07-388B-D3A1-86A1D30FF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34D4168-7AFE-1A78-5987-D9A2D0E646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FA62468-937E-1914-7D21-B001FB8D6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306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1A1FE4-8228-5248-EECA-F4599761BD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A59171E-21C1-AD11-82A4-EE2FB25FA3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862B302-3EC7-AF75-5A6D-6FB7CBB81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09D843C-3C67-9C03-8DCA-EE86AA637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2CA45B2-308C-1FE2-4734-38399CC623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541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1611711-578E-49E4-9397-32FF2751CA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6865BB4-80C9-D4ED-7F0E-D8BABB0F6B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951C474-B2B7-05C5-E311-213366592C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6F02DFD-3CFB-3902-43C3-35225EA52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C805600-FA89-1D64-A2BA-E62D71523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F844A8A-0E89-7FB8-4BCD-D4D643EB6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2425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2F1871-2654-A3E3-5001-E578B260E6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4A954AD-225F-2671-1DBB-51A831766E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11EDBDF-2CC3-54F2-5013-D08E8CAADC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C6101E5-4AC5-536A-D3FD-BEB54174FA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441C12A-FD06-059B-B9D9-51681061D6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4C014235-B0B7-6252-41F0-E959658D8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6780C14-D6C9-B255-77CC-C42004679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2AED8E4-066D-6175-C19F-23DBF2C8C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6747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CAF1CF-F163-88CA-E7F0-45AD905F1A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53C53977-E277-AFD7-D549-702D12997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F4BCD8C-3781-21CA-FDF4-0081A417A2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5BDE15CA-8867-C739-C447-33A1B3869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290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E8B5CB80-373F-A9A4-8AD9-0DF31FDA2C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C629FB7-11EC-2E2F-D00D-A4112F429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CFE63BE-B62A-32F3-5D15-4F05953F8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8935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2DCEA87-F8C9-C5B1-B4CD-1ECEEC6306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3108EA0-9BB8-6851-2B42-BB26043E5D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88E0B95-7668-858A-D89A-4BEEAC04D1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E9989BC-B9AC-07CE-509C-8AE84AC02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003A3E8-41A5-BD46-E8DF-78534100B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7670E61-5340-E33A-43DD-AAFDF45A5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0291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D5E52B-A01F-B58E-FE8A-D95B4D0561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589AAD1-DE06-C3DF-4C69-212DB1266E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9294984-1984-C4EF-1A25-9C8857D8A0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0018E46-BC75-2C8B-18F7-A5632F43B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7046928-0D28-A1D9-B0A8-B603A4AC0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7A73E73-1CE8-F076-35E1-A8CDEE091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8527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584C29AB-1D04-98C9-E9FE-92AAAF8ED8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3C41C5E-59FE-5FB0-102E-1740B2E024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B107498-9D99-AEC6-89EE-742B73D36E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C3870A-6082-436D-9360-8C3954261161}" type="datetimeFigureOut">
              <a:rPr lang="es-ES" smtClean="0"/>
              <a:t>19/08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BD8D75B-84B6-102B-8F4D-40EB495765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84EB90A-4EE6-DEE5-99B8-621711E42A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9AA1D4-7221-4C21-A01C-5018BA8114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6084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CuadroTexto 22">
            <a:extLst>
              <a:ext uri="{FF2B5EF4-FFF2-40B4-BE49-F238E27FC236}">
                <a16:creationId xmlns:a16="http://schemas.microsoft.com/office/drawing/2014/main" id="{B2BC3D69-E606-480F-7DA2-46F755782CE7}"/>
              </a:ext>
            </a:extLst>
          </p:cNvPr>
          <p:cNvSpPr txBox="1"/>
          <p:nvPr/>
        </p:nvSpPr>
        <p:spPr>
          <a:xfrm>
            <a:off x="0" y="32672"/>
            <a:ext cx="229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err="1"/>
              <a:t>Suppl</a:t>
            </a:r>
            <a:r>
              <a:rPr lang="es-ES" b="1"/>
              <a:t>. Fig. 1</a:t>
            </a:r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7129FA01-25F6-EA40-77A0-B18991141AD2}"/>
              </a:ext>
            </a:extLst>
          </p:cNvPr>
          <p:cNvGrpSpPr/>
          <p:nvPr/>
        </p:nvGrpSpPr>
        <p:grpSpPr>
          <a:xfrm>
            <a:off x="192505" y="1121229"/>
            <a:ext cx="11546303" cy="3901708"/>
            <a:chOff x="192505" y="1121229"/>
            <a:chExt cx="11546303" cy="3901708"/>
          </a:xfrm>
        </p:grpSpPr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119AC930-2179-C6D6-ED73-DC67C1E4B142}"/>
                </a:ext>
              </a:extLst>
            </p:cNvPr>
            <p:cNvGrpSpPr/>
            <p:nvPr/>
          </p:nvGrpSpPr>
          <p:grpSpPr>
            <a:xfrm>
              <a:off x="4480640" y="2154082"/>
              <a:ext cx="3407015" cy="2274705"/>
              <a:chOff x="779190" y="4422082"/>
              <a:chExt cx="2828349" cy="1758783"/>
            </a:xfrm>
          </p:grpSpPr>
          <p:pic>
            <p:nvPicPr>
              <p:cNvPr id="5" name="Imagen 4">
                <a:extLst>
                  <a:ext uri="{FF2B5EF4-FFF2-40B4-BE49-F238E27FC236}">
                    <a16:creationId xmlns:a16="http://schemas.microsoft.com/office/drawing/2014/main" id="{D0945852-9C3E-BE9A-0DB5-E5256AE555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32126" t="35847" r="27086" b="18949"/>
              <a:stretch/>
            </p:blipFill>
            <p:spPr>
              <a:xfrm>
                <a:off x="779190" y="4422082"/>
                <a:ext cx="2828349" cy="1758783"/>
              </a:xfrm>
              <a:prstGeom prst="rect">
                <a:avLst/>
              </a:prstGeom>
            </p:spPr>
          </p:pic>
          <p:grpSp>
            <p:nvGrpSpPr>
              <p:cNvPr id="6" name="Grupo 5">
                <a:extLst>
                  <a:ext uri="{FF2B5EF4-FFF2-40B4-BE49-F238E27FC236}">
                    <a16:creationId xmlns:a16="http://schemas.microsoft.com/office/drawing/2014/main" id="{5E4872BE-DBDC-3446-FFB9-3C995E673207}"/>
                  </a:ext>
                </a:extLst>
              </p:cNvPr>
              <p:cNvGrpSpPr/>
              <p:nvPr/>
            </p:nvGrpSpPr>
            <p:grpSpPr>
              <a:xfrm>
                <a:off x="1186163" y="4919894"/>
                <a:ext cx="2224162" cy="885949"/>
                <a:chOff x="2804022" y="1232470"/>
                <a:chExt cx="2037498" cy="813231"/>
              </a:xfrm>
            </p:grpSpPr>
            <p:sp>
              <p:nvSpPr>
                <p:cNvPr id="7" name="CuadroTexto 6">
                  <a:extLst>
                    <a:ext uri="{FF2B5EF4-FFF2-40B4-BE49-F238E27FC236}">
                      <a16:creationId xmlns:a16="http://schemas.microsoft.com/office/drawing/2014/main" id="{DDC1CDA8-F1FF-D92D-B9C9-AFA7264981FB}"/>
                    </a:ext>
                  </a:extLst>
                </p:cNvPr>
                <p:cNvSpPr txBox="1"/>
                <p:nvPr/>
              </p:nvSpPr>
              <p:spPr>
                <a:xfrm>
                  <a:off x="3580643" y="1454627"/>
                  <a:ext cx="749300" cy="2621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b="1" dirty="0">
                      <a:solidFill>
                        <a:schemeClr val="bg1"/>
                      </a:solidFill>
                    </a:rPr>
                    <a:t>94</a:t>
                  </a:r>
                </a:p>
              </p:txBody>
            </p:sp>
            <p:sp>
              <p:nvSpPr>
                <p:cNvPr id="8" name="CuadroTexto 7">
                  <a:extLst>
                    <a:ext uri="{FF2B5EF4-FFF2-40B4-BE49-F238E27FC236}">
                      <a16:creationId xmlns:a16="http://schemas.microsoft.com/office/drawing/2014/main" id="{D57A3E96-B386-29DD-D433-12768A14A77E}"/>
                    </a:ext>
                  </a:extLst>
                </p:cNvPr>
                <p:cNvSpPr txBox="1"/>
                <p:nvPr/>
              </p:nvSpPr>
              <p:spPr>
                <a:xfrm>
                  <a:off x="4092220" y="1251007"/>
                  <a:ext cx="749300" cy="2621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b="1" dirty="0">
                      <a:solidFill>
                        <a:schemeClr val="bg1"/>
                      </a:solidFill>
                    </a:rPr>
                    <a:t>1051</a:t>
                  </a:r>
                </a:p>
              </p:txBody>
            </p:sp>
            <p:sp>
              <p:nvSpPr>
                <p:cNvPr id="9" name="CuadroTexto 8">
                  <a:extLst>
                    <a:ext uri="{FF2B5EF4-FFF2-40B4-BE49-F238E27FC236}">
                      <a16:creationId xmlns:a16="http://schemas.microsoft.com/office/drawing/2014/main" id="{5F044EED-E018-6C6E-2AE9-4D85BDC3CCE8}"/>
                    </a:ext>
                  </a:extLst>
                </p:cNvPr>
                <p:cNvSpPr txBox="1"/>
                <p:nvPr/>
              </p:nvSpPr>
              <p:spPr>
                <a:xfrm>
                  <a:off x="2857635" y="1232470"/>
                  <a:ext cx="749300" cy="2621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b="1" dirty="0">
                      <a:solidFill>
                        <a:schemeClr val="bg1"/>
                      </a:solidFill>
                    </a:rPr>
                    <a:t>23</a:t>
                  </a:r>
                </a:p>
              </p:txBody>
            </p:sp>
            <p:sp>
              <p:nvSpPr>
                <p:cNvPr id="10" name="CuadroTexto 9">
                  <a:extLst>
                    <a:ext uri="{FF2B5EF4-FFF2-40B4-BE49-F238E27FC236}">
                      <a16:creationId xmlns:a16="http://schemas.microsoft.com/office/drawing/2014/main" id="{AB8F37C7-C9DB-5624-FC7C-7195E01DCAC6}"/>
                    </a:ext>
                  </a:extLst>
                </p:cNvPr>
                <p:cNvSpPr txBox="1"/>
                <p:nvPr/>
              </p:nvSpPr>
              <p:spPr>
                <a:xfrm>
                  <a:off x="2804022" y="1608226"/>
                  <a:ext cx="521895" cy="4237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200">
                      <a:solidFill>
                        <a:schemeClr val="bg1"/>
                      </a:solidFill>
                    </a:rPr>
                    <a:t>PEVs </a:t>
                  </a:r>
                </a:p>
                <a:p>
                  <a:pPr algn="ctr"/>
                  <a:r>
                    <a:rPr lang="es-ES" sz="1200">
                      <a:solidFill>
                        <a:schemeClr val="bg1"/>
                      </a:solidFill>
                    </a:rPr>
                    <a:t>lysis</a:t>
                  </a:r>
                </a:p>
              </p:txBody>
            </p:sp>
            <p:sp>
              <p:nvSpPr>
                <p:cNvPr id="11" name="CuadroTexto 10">
                  <a:extLst>
                    <a:ext uri="{FF2B5EF4-FFF2-40B4-BE49-F238E27FC236}">
                      <a16:creationId xmlns:a16="http://schemas.microsoft.com/office/drawing/2014/main" id="{3F6FB4EB-2D56-1155-2D0F-4FF304540ACB}"/>
                    </a:ext>
                  </a:extLst>
                </p:cNvPr>
                <p:cNvSpPr txBox="1"/>
                <p:nvPr/>
              </p:nvSpPr>
              <p:spPr>
                <a:xfrm>
                  <a:off x="3854083" y="1621929"/>
                  <a:ext cx="985167" cy="4237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s-ES" sz="1200">
                      <a:solidFill>
                        <a:schemeClr val="bg1"/>
                      </a:solidFill>
                    </a:rPr>
                    <a:t>Protein</a:t>
                  </a:r>
                </a:p>
                <a:p>
                  <a:r>
                    <a:rPr lang="es-ES" sz="1200">
                      <a:solidFill>
                        <a:schemeClr val="bg1"/>
                      </a:solidFill>
                    </a:rPr>
                    <a:t>solubilization</a:t>
                  </a:r>
                </a:p>
              </p:txBody>
            </p:sp>
          </p:grpSp>
        </p:grpSp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E7287B23-EBBA-69DA-1F61-FBD5B8C77B26}"/>
                </a:ext>
              </a:extLst>
            </p:cNvPr>
            <p:cNvGrpSpPr/>
            <p:nvPr/>
          </p:nvGrpSpPr>
          <p:grpSpPr>
            <a:xfrm>
              <a:off x="309356" y="1592938"/>
              <a:ext cx="3593531" cy="3429999"/>
              <a:chOff x="2460524" y="3087063"/>
              <a:chExt cx="3236676" cy="3117954"/>
            </a:xfrm>
          </p:grpSpPr>
          <p:pic>
            <p:nvPicPr>
              <p:cNvPr id="13" name="Imagen 12">
                <a:extLst>
                  <a:ext uri="{FF2B5EF4-FFF2-40B4-BE49-F238E27FC236}">
                    <a16:creationId xmlns:a16="http://schemas.microsoft.com/office/drawing/2014/main" id="{02348C50-01CB-37AD-D971-B06A1106DE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45196" t="35431" r="28256" b="19082"/>
              <a:stretch/>
            </p:blipFill>
            <p:spPr>
              <a:xfrm>
                <a:off x="2460524" y="3087063"/>
                <a:ext cx="3236676" cy="3117954"/>
              </a:xfrm>
              <a:prstGeom prst="rect">
                <a:avLst/>
              </a:prstGeom>
            </p:spPr>
          </p:pic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id="{220D3954-3F6D-1FE9-4CE3-8070FA492CF8}"/>
                  </a:ext>
                </a:extLst>
              </p:cNvPr>
              <p:cNvSpPr txBox="1"/>
              <p:nvPr/>
            </p:nvSpPr>
            <p:spPr>
              <a:xfrm>
                <a:off x="2698721" y="3657908"/>
                <a:ext cx="1045541" cy="3358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 dirty="0">
                    <a:solidFill>
                      <a:schemeClr val="bg1"/>
                    </a:solidFill>
                  </a:rPr>
                  <a:t>185</a:t>
                </a:r>
                <a:endParaRPr lang="es-E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id="{85AC51ED-8F2B-C665-72CA-3013B0DB84D6}"/>
                  </a:ext>
                </a:extLst>
              </p:cNvPr>
              <p:cNvSpPr txBox="1"/>
              <p:nvPr/>
            </p:nvSpPr>
            <p:spPr>
              <a:xfrm>
                <a:off x="4492115" y="3687372"/>
                <a:ext cx="1045541" cy="5316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 dirty="0">
                    <a:solidFill>
                      <a:schemeClr val="bg1"/>
                    </a:solidFill>
                  </a:rPr>
                  <a:t>13</a:t>
                </a:r>
              </a:p>
              <a:p>
                <a:pPr algn="ctr"/>
                <a:endParaRPr lang="es-E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85B70D09-0297-96B1-635B-7A434E5B8779}"/>
                  </a:ext>
                </a:extLst>
              </p:cNvPr>
              <p:cNvSpPr txBox="1"/>
              <p:nvPr/>
            </p:nvSpPr>
            <p:spPr>
              <a:xfrm>
                <a:off x="3592413" y="5249832"/>
                <a:ext cx="1045541" cy="3358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 dirty="0">
                    <a:solidFill>
                      <a:schemeClr val="bg1"/>
                    </a:solidFill>
                  </a:rPr>
                  <a:t>58</a:t>
                </a:r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14913508-84A6-E7C7-2B63-AEF274280D4E}"/>
                  </a:ext>
                </a:extLst>
              </p:cNvPr>
              <p:cNvSpPr txBox="1"/>
              <p:nvPr/>
            </p:nvSpPr>
            <p:spPr>
              <a:xfrm>
                <a:off x="3030318" y="4505061"/>
                <a:ext cx="1045541" cy="3358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 dirty="0">
                    <a:solidFill>
                      <a:schemeClr val="bg1"/>
                    </a:solidFill>
                  </a:rPr>
                  <a:t>108</a:t>
                </a:r>
              </a:p>
            </p:txBody>
          </p:sp>
          <p:sp>
            <p:nvSpPr>
              <p:cNvPr id="18" name="CuadroTexto 17">
                <a:extLst>
                  <a:ext uri="{FF2B5EF4-FFF2-40B4-BE49-F238E27FC236}">
                    <a16:creationId xmlns:a16="http://schemas.microsoft.com/office/drawing/2014/main" id="{BE3CBA9F-C927-DE65-4E5D-7B8FA5A6AE2A}"/>
                  </a:ext>
                </a:extLst>
              </p:cNvPr>
              <p:cNvSpPr txBox="1"/>
              <p:nvPr/>
            </p:nvSpPr>
            <p:spPr>
              <a:xfrm>
                <a:off x="4079475" y="4566936"/>
                <a:ext cx="1045541" cy="3358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 dirty="0">
                    <a:solidFill>
                      <a:schemeClr val="bg1"/>
                    </a:solidFill>
                  </a:rPr>
                  <a:t>9</a:t>
                </a:r>
              </a:p>
            </p:txBody>
          </p:sp>
          <p:sp>
            <p:nvSpPr>
              <p:cNvPr id="19" name="CuadroTexto 18">
                <a:extLst>
                  <a:ext uri="{FF2B5EF4-FFF2-40B4-BE49-F238E27FC236}">
                    <a16:creationId xmlns:a16="http://schemas.microsoft.com/office/drawing/2014/main" id="{1E953F20-42A3-D3A0-167C-8F1B41712E89}"/>
                  </a:ext>
                </a:extLst>
              </p:cNvPr>
              <p:cNvSpPr txBox="1"/>
              <p:nvPr/>
            </p:nvSpPr>
            <p:spPr>
              <a:xfrm>
                <a:off x="3553087" y="3664124"/>
                <a:ext cx="1045541" cy="3358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 dirty="0">
                    <a:solidFill>
                      <a:schemeClr val="bg1"/>
                    </a:solidFill>
                  </a:rPr>
                  <a:t>14</a:t>
                </a:r>
                <a:endParaRPr lang="es-E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0" name="CuadroTexto 19">
                <a:extLst>
                  <a:ext uri="{FF2B5EF4-FFF2-40B4-BE49-F238E27FC236}">
                    <a16:creationId xmlns:a16="http://schemas.microsoft.com/office/drawing/2014/main" id="{85F9DBC3-9E0B-974C-8469-086904153C96}"/>
                  </a:ext>
                </a:extLst>
              </p:cNvPr>
              <p:cNvSpPr txBox="1"/>
              <p:nvPr/>
            </p:nvSpPr>
            <p:spPr>
              <a:xfrm>
                <a:off x="3561853" y="4205197"/>
                <a:ext cx="1045540" cy="419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2400" b="1" dirty="0"/>
                  <a:t>117</a:t>
                </a:r>
              </a:p>
            </p:txBody>
          </p:sp>
        </p:grp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B2272727-A934-776C-55A2-7B26AD26678D}"/>
                </a:ext>
              </a:extLst>
            </p:cNvPr>
            <p:cNvSpPr txBox="1"/>
            <p:nvPr/>
          </p:nvSpPr>
          <p:spPr>
            <a:xfrm>
              <a:off x="4341894" y="1121229"/>
              <a:ext cx="22908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/>
                <a:t>B)</a:t>
              </a: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951AF9FA-2E43-D866-B9F8-E5FB4574BCEC}"/>
                </a:ext>
              </a:extLst>
            </p:cNvPr>
            <p:cNvSpPr txBox="1"/>
            <p:nvPr/>
          </p:nvSpPr>
          <p:spPr>
            <a:xfrm>
              <a:off x="192505" y="1121229"/>
              <a:ext cx="10266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/>
                <a:t>A)</a:t>
              </a:r>
            </a:p>
          </p:txBody>
        </p:sp>
        <p:grpSp>
          <p:nvGrpSpPr>
            <p:cNvPr id="24" name="Grupo 23">
              <a:extLst>
                <a:ext uri="{FF2B5EF4-FFF2-40B4-BE49-F238E27FC236}">
                  <a16:creationId xmlns:a16="http://schemas.microsoft.com/office/drawing/2014/main" id="{D35B3257-C5A9-0F51-6296-E08C8D8591E9}"/>
                </a:ext>
              </a:extLst>
            </p:cNvPr>
            <p:cNvGrpSpPr/>
            <p:nvPr/>
          </p:nvGrpSpPr>
          <p:grpSpPr>
            <a:xfrm>
              <a:off x="8331794" y="1710687"/>
              <a:ext cx="3407014" cy="3312250"/>
              <a:chOff x="2460524" y="3087063"/>
              <a:chExt cx="3236676" cy="3117954"/>
            </a:xfrm>
          </p:grpSpPr>
          <p:pic>
            <p:nvPicPr>
              <p:cNvPr id="25" name="Imagen 24">
                <a:extLst>
                  <a:ext uri="{FF2B5EF4-FFF2-40B4-BE49-F238E27FC236}">
                    <a16:creationId xmlns:a16="http://schemas.microsoft.com/office/drawing/2014/main" id="{DD7ABDC1-3995-97FC-4E3F-4ADE94414F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45196" t="35431" r="28256" b="19082"/>
              <a:stretch/>
            </p:blipFill>
            <p:spPr>
              <a:xfrm>
                <a:off x="2460524" y="3087063"/>
                <a:ext cx="3236676" cy="3117954"/>
              </a:xfrm>
              <a:prstGeom prst="rect">
                <a:avLst/>
              </a:prstGeom>
            </p:spPr>
          </p:pic>
          <p:sp>
            <p:nvSpPr>
              <p:cNvPr id="26" name="CuadroTexto 25">
                <a:extLst>
                  <a:ext uri="{FF2B5EF4-FFF2-40B4-BE49-F238E27FC236}">
                    <a16:creationId xmlns:a16="http://schemas.microsoft.com/office/drawing/2014/main" id="{836AD873-BA4C-95F9-B4A5-C31805891BFB}"/>
                  </a:ext>
                </a:extLst>
              </p:cNvPr>
              <p:cNvSpPr txBox="1"/>
              <p:nvPr/>
            </p:nvSpPr>
            <p:spPr>
              <a:xfrm>
                <a:off x="2698721" y="3657908"/>
                <a:ext cx="1045541" cy="415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>
                    <a:solidFill>
                      <a:schemeClr val="bg1"/>
                    </a:solidFill>
                  </a:rPr>
                  <a:t>6</a:t>
                </a:r>
                <a:endParaRPr lang="es-ES" sz="1400" b="1">
                  <a:solidFill>
                    <a:schemeClr val="bg1"/>
                  </a:solidFill>
                </a:endParaRPr>
              </a:p>
            </p:txBody>
          </p:sp>
          <p:sp>
            <p:nvSpPr>
              <p:cNvPr id="27" name="CuadroTexto 26">
                <a:extLst>
                  <a:ext uri="{FF2B5EF4-FFF2-40B4-BE49-F238E27FC236}">
                    <a16:creationId xmlns:a16="http://schemas.microsoft.com/office/drawing/2014/main" id="{5453F462-3985-385E-5056-98934354CF39}"/>
                  </a:ext>
                </a:extLst>
              </p:cNvPr>
              <p:cNvSpPr txBox="1"/>
              <p:nvPr/>
            </p:nvSpPr>
            <p:spPr>
              <a:xfrm>
                <a:off x="4492115" y="3687372"/>
                <a:ext cx="1045541" cy="6571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>
                    <a:solidFill>
                      <a:schemeClr val="bg1"/>
                    </a:solidFill>
                  </a:rPr>
                  <a:t>23</a:t>
                </a:r>
              </a:p>
              <a:p>
                <a:pPr algn="ctr"/>
                <a:endParaRPr lang="es-ES" sz="1400" b="1">
                  <a:solidFill>
                    <a:schemeClr val="bg1"/>
                  </a:solidFill>
                </a:endParaRPr>
              </a:p>
            </p:txBody>
          </p:sp>
          <p:sp>
            <p:nvSpPr>
              <p:cNvPr id="28" name="CuadroTexto 27">
                <a:extLst>
                  <a:ext uri="{FF2B5EF4-FFF2-40B4-BE49-F238E27FC236}">
                    <a16:creationId xmlns:a16="http://schemas.microsoft.com/office/drawing/2014/main" id="{FFAE1ED5-3D2C-668A-0BD4-5B0908C613DE}"/>
                  </a:ext>
                </a:extLst>
              </p:cNvPr>
              <p:cNvSpPr txBox="1"/>
              <p:nvPr/>
            </p:nvSpPr>
            <p:spPr>
              <a:xfrm>
                <a:off x="3592413" y="5249832"/>
                <a:ext cx="1045541" cy="415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>
                    <a:solidFill>
                      <a:schemeClr val="bg1"/>
                    </a:solidFill>
                  </a:rPr>
                  <a:t>19</a:t>
                </a:r>
              </a:p>
            </p:txBody>
          </p:sp>
          <p:sp>
            <p:nvSpPr>
              <p:cNvPr id="29" name="CuadroTexto 28">
                <a:extLst>
                  <a:ext uri="{FF2B5EF4-FFF2-40B4-BE49-F238E27FC236}">
                    <a16:creationId xmlns:a16="http://schemas.microsoft.com/office/drawing/2014/main" id="{0A308AB1-7215-77F1-6082-26EB3C55134E}"/>
                  </a:ext>
                </a:extLst>
              </p:cNvPr>
              <p:cNvSpPr txBox="1"/>
              <p:nvPr/>
            </p:nvSpPr>
            <p:spPr>
              <a:xfrm>
                <a:off x="3030318" y="4505061"/>
                <a:ext cx="1045541" cy="415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>
                    <a:solidFill>
                      <a:schemeClr val="bg1"/>
                    </a:solidFill>
                  </a:rPr>
                  <a:t>1</a:t>
                </a:r>
              </a:p>
            </p:txBody>
          </p:sp>
          <p:sp>
            <p:nvSpPr>
              <p:cNvPr id="30" name="CuadroTexto 29">
                <a:extLst>
                  <a:ext uri="{FF2B5EF4-FFF2-40B4-BE49-F238E27FC236}">
                    <a16:creationId xmlns:a16="http://schemas.microsoft.com/office/drawing/2014/main" id="{A3BED0A0-B90E-EC82-B505-2548282C9C6D}"/>
                  </a:ext>
                </a:extLst>
              </p:cNvPr>
              <p:cNvSpPr txBox="1"/>
              <p:nvPr/>
            </p:nvSpPr>
            <p:spPr>
              <a:xfrm>
                <a:off x="4079475" y="4566936"/>
                <a:ext cx="1045541" cy="415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>
                    <a:solidFill>
                      <a:schemeClr val="bg1"/>
                    </a:solidFill>
                  </a:rPr>
                  <a:t>788</a:t>
                </a:r>
              </a:p>
            </p:txBody>
          </p:sp>
          <p:sp>
            <p:nvSpPr>
              <p:cNvPr id="31" name="CuadroTexto 30">
                <a:extLst>
                  <a:ext uri="{FF2B5EF4-FFF2-40B4-BE49-F238E27FC236}">
                    <a16:creationId xmlns:a16="http://schemas.microsoft.com/office/drawing/2014/main" id="{DC0C567E-1141-1F05-EC37-A499DD7C984E}"/>
                  </a:ext>
                </a:extLst>
              </p:cNvPr>
              <p:cNvSpPr txBox="1"/>
              <p:nvPr/>
            </p:nvSpPr>
            <p:spPr>
              <a:xfrm>
                <a:off x="3553087" y="3664124"/>
                <a:ext cx="1045541" cy="415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801" b="1">
                    <a:solidFill>
                      <a:schemeClr val="bg1"/>
                    </a:solidFill>
                  </a:rPr>
                  <a:t>6</a:t>
                </a:r>
                <a:endParaRPr lang="es-ES" sz="1400" b="1">
                  <a:solidFill>
                    <a:schemeClr val="bg1"/>
                  </a:solidFill>
                </a:endParaRPr>
              </a:p>
            </p:txBody>
          </p:sp>
          <p:sp>
            <p:nvSpPr>
              <p:cNvPr id="32" name="CuadroTexto 31">
                <a:extLst>
                  <a:ext uri="{FF2B5EF4-FFF2-40B4-BE49-F238E27FC236}">
                    <a16:creationId xmlns:a16="http://schemas.microsoft.com/office/drawing/2014/main" id="{6F8103E9-7532-2A9B-F5B6-1255F4D6FA5E}"/>
                  </a:ext>
                </a:extLst>
              </p:cNvPr>
              <p:cNvSpPr txBox="1"/>
              <p:nvPr/>
            </p:nvSpPr>
            <p:spPr>
              <a:xfrm>
                <a:off x="3561853" y="4243722"/>
                <a:ext cx="1045540" cy="5186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2400" b="1"/>
                  <a:t>1370</a:t>
                </a:r>
              </a:p>
            </p:txBody>
          </p:sp>
        </p:grp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05CC4E4F-4BCD-54AF-9537-D13F41DA97A5}"/>
                </a:ext>
              </a:extLst>
            </p:cNvPr>
            <p:cNvSpPr txBox="1"/>
            <p:nvPr/>
          </p:nvSpPr>
          <p:spPr>
            <a:xfrm>
              <a:off x="7703430" y="1121229"/>
              <a:ext cx="22908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/>
                <a:t>C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27273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 descr="Gráfico&#10;&#10;El contenido generado por IA puede ser incorrecto.">
            <a:extLst>
              <a:ext uri="{FF2B5EF4-FFF2-40B4-BE49-F238E27FC236}">
                <a16:creationId xmlns:a16="http://schemas.microsoft.com/office/drawing/2014/main" id="{68B9F44B-BAB2-F094-1EDD-CC079DE4A3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475" y="2036248"/>
            <a:ext cx="5620273" cy="4348732"/>
          </a:xfrm>
          <a:prstGeom prst="rect">
            <a:avLst/>
          </a:prstGeom>
        </p:spPr>
      </p:pic>
      <p:pic>
        <p:nvPicPr>
          <p:cNvPr id="5" name="Marcador de contenido 4" descr="Gráfico, Gráfico de líneas&#10;&#10;El contenido generado por IA puede ser incorrecto.">
            <a:extLst>
              <a:ext uri="{FF2B5EF4-FFF2-40B4-BE49-F238E27FC236}">
                <a16:creationId xmlns:a16="http://schemas.microsoft.com/office/drawing/2014/main" id="{B6331410-957C-6BA4-2AF5-14D3F430188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2073" y="2035173"/>
            <a:ext cx="5620274" cy="4348732"/>
          </a:xfrm>
        </p:spPr>
      </p:pic>
      <p:sp>
        <p:nvSpPr>
          <p:cNvPr id="10" name="Rectángulo 9">
            <a:extLst>
              <a:ext uri="{FF2B5EF4-FFF2-40B4-BE49-F238E27FC236}">
                <a16:creationId xmlns:a16="http://schemas.microsoft.com/office/drawing/2014/main" id="{8064D34B-57D6-91D1-ABEE-D9AB92C36939}"/>
              </a:ext>
            </a:extLst>
          </p:cNvPr>
          <p:cNvSpPr/>
          <p:nvPr/>
        </p:nvSpPr>
        <p:spPr>
          <a:xfrm>
            <a:off x="6094847" y="1740101"/>
            <a:ext cx="2008112" cy="4793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AB47F25A-A22A-208B-09CC-3A41BE242C50}"/>
              </a:ext>
            </a:extLst>
          </p:cNvPr>
          <p:cNvSpPr txBox="1"/>
          <p:nvPr/>
        </p:nvSpPr>
        <p:spPr>
          <a:xfrm>
            <a:off x="0" y="32672"/>
            <a:ext cx="229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err="1"/>
              <a:t>Suppl</a:t>
            </a:r>
            <a:r>
              <a:rPr lang="es-ES" b="1"/>
              <a:t>. Fig. 2</a:t>
            </a:r>
          </a:p>
        </p:txBody>
      </p:sp>
      <p:grpSp>
        <p:nvGrpSpPr>
          <p:cNvPr id="13" name="Grupo 12">
            <a:extLst>
              <a:ext uri="{FF2B5EF4-FFF2-40B4-BE49-F238E27FC236}">
                <a16:creationId xmlns:a16="http://schemas.microsoft.com/office/drawing/2014/main" id="{AC7A3E6E-B49C-7B7F-5A3E-E1495FCE609C}"/>
              </a:ext>
            </a:extLst>
          </p:cNvPr>
          <p:cNvGrpSpPr/>
          <p:nvPr/>
        </p:nvGrpSpPr>
        <p:grpSpPr>
          <a:xfrm>
            <a:off x="375385" y="958149"/>
            <a:ext cx="11816615" cy="1257504"/>
            <a:chOff x="375385" y="958149"/>
            <a:chExt cx="11816615" cy="1257504"/>
          </a:xfrm>
        </p:grpSpPr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C8EC683C-5746-4A86-05C3-DD941470DA91}"/>
                </a:ext>
              </a:extLst>
            </p:cNvPr>
            <p:cNvSpPr txBox="1"/>
            <p:nvPr/>
          </p:nvSpPr>
          <p:spPr>
            <a:xfrm>
              <a:off x="375385" y="958149"/>
              <a:ext cx="5871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/>
                <a:t>A)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98B396FD-C76B-13A0-EDB2-883D684EDB47}"/>
                </a:ext>
              </a:extLst>
            </p:cNvPr>
            <p:cNvSpPr txBox="1"/>
            <p:nvPr/>
          </p:nvSpPr>
          <p:spPr>
            <a:xfrm>
              <a:off x="5869182" y="1016127"/>
              <a:ext cx="5871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/>
                <a:t>B)</a:t>
              </a:r>
            </a:p>
          </p:txBody>
        </p:sp>
        <p:sp>
          <p:nvSpPr>
            <p:cNvPr id="9" name="Rectángulo 8">
              <a:extLst>
                <a:ext uri="{FF2B5EF4-FFF2-40B4-BE49-F238E27FC236}">
                  <a16:creationId xmlns:a16="http://schemas.microsoft.com/office/drawing/2014/main" id="{531FD52B-7CA6-E7A9-B04B-92C091F30A97}"/>
                </a:ext>
              </a:extLst>
            </p:cNvPr>
            <p:cNvSpPr/>
            <p:nvPr/>
          </p:nvSpPr>
          <p:spPr>
            <a:xfrm>
              <a:off x="431800" y="1736294"/>
              <a:ext cx="2008112" cy="47935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27237318-FC62-F294-7384-4750E105D63E}"/>
                </a:ext>
              </a:extLst>
            </p:cNvPr>
            <p:cNvSpPr txBox="1"/>
            <p:nvPr/>
          </p:nvSpPr>
          <p:spPr>
            <a:xfrm>
              <a:off x="774448" y="1334468"/>
              <a:ext cx="518930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500" dirty="0"/>
                <a:t>Arath-</a:t>
              </a:r>
              <a:r>
                <a:rPr lang="es-ES" sz="1500" dirty="0" err="1"/>
                <a:t>EVs</a:t>
              </a:r>
              <a:r>
                <a:rPr lang="es-ES" sz="1500" dirty="0"/>
                <a:t> </a:t>
              </a:r>
              <a:r>
                <a:rPr lang="es-ES" sz="1500" dirty="0" err="1"/>
                <a:t>lysis</a:t>
              </a:r>
              <a:r>
                <a:rPr lang="es-ES" sz="1500" dirty="0"/>
                <a:t>            </a:t>
              </a:r>
              <a:r>
                <a:rPr lang="es-ES" sz="1500" dirty="0" err="1"/>
                <a:t>Protein</a:t>
              </a:r>
              <a:r>
                <a:rPr lang="es-ES" sz="1500" dirty="0"/>
                <a:t> </a:t>
              </a:r>
              <a:r>
                <a:rPr lang="es-ES" sz="1500" dirty="0" err="1"/>
                <a:t>solubilization</a:t>
              </a:r>
              <a:r>
                <a:rPr lang="es-ES" sz="1500" dirty="0"/>
                <a:t> Arath-</a:t>
              </a:r>
              <a:r>
                <a:rPr lang="es-ES" sz="1500" dirty="0" err="1"/>
                <a:t>EVs</a:t>
              </a:r>
              <a:endParaRPr lang="es-ES" sz="150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BB847C46-EF6D-B150-220B-B38BB3434AB2}"/>
                </a:ext>
              </a:extLst>
            </p:cNvPr>
            <p:cNvSpPr txBox="1"/>
            <p:nvPr/>
          </p:nvSpPr>
          <p:spPr>
            <a:xfrm>
              <a:off x="6225941" y="1465852"/>
              <a:ext cx="596605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500" dirty="0" err="1"/>
                <a:t>Fraction</a:t>
              </a:r>
              <a:r>
                <a:rPr lang="es-ES" sz="1500" dirty="0"/>
                <a:t> </a:t>
              </a:r>
              <a:r>
                <a:rPr lang="es-ES" sz="1500" dirty="0" err="1"/>
                <a:t>without</a:t>
              </a:r>
              <a:r>
                <a:rPr lang="es-ES" sz="1500" dirty="0"/>
                <a:t> </a:t>
              </a:r>
              <a:r>
                <a:rPr lang="es-ES" sz="1500" dirty="0" err="1"/>
                <a:t>EVs</a:t>
              </a:r>
              <a:r>
                <a:rPr lang="es-ES" sz="1500" dirty="0"/>
                <a:t>                </a:t>
              </a:r>
              <a:r>
                <a:rPr lang="es-ES" sz="1500" dirty="0" err="1"/>
                <a:t>Portein</a:t>
              </a:r>
              <a:r>
                <a:rPr lang="es-ES" sz="1500" dirty="0"/>
                <a:t> </a:t>
              </a:r>
              <a:r>
                <a:rPr lang="es-ES" sz="1500" dirty="0" err="1"/>
                <a:t>solubilization</a:t>
              </a:r>
              <a:r>
                <a:rPr lang="es-ES" sz="1500" dirty="0"/>
                <a:t> Arath-</a:t>
              </a:r>
              <a:r>
                <a:rPr lang="es-ES" sz="1500" dirty="0" err="1"/>
                <a:t>EVs</a:t>
              </a:r>
              <a:endParaRPr lang="es-ES" sz="1500" dirty="0"/>
            </a:p>
          </p:txBody>
        </p:sp>
        <p:sp>
          <p:nvSpPr>
            <p:cNvPr id="12" name="Rectángulo 11">
              <a:extLst>
                <a:ext uri="{FF2B5EF4-FFF2-40B4-BE49-F238E27FC236}">
                  <a16:creationId xmlns:a16="http://schemas.microsoft.com/office/drawing/2014/main" id="{9FEC0CB4-23BD-95C1-2E32-07F61838C013}"/>
                </a:ext>
              </a:extLst>
            </p:cNvPr>
            <p:cNvSpPr/>
            <p:nvPr/>
          </p:nvSpPr>
          <p:spPr>
            <a:xfrm>
              <a:off x="470301" y="1368813"/>
              <a:ext cx="298198" cy="26277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" name="Rectángulo 15">
              <a:extLst>
                <a:ext uri="{FF2B5EF4-FFF2-40B4-BE49-F238E27FC236}">
                  <a16:creationId xmlns:a16="http://schemas.microsoft.com/office/drawing/2014/main" id="{9276294F-575B-F512-8D20-AEB17430F2B8}"/>
                </a:ext>
              </a:extLst>
            </p:cNvPr>
            <p:cNvSpPr/>
            <p:nvPr/>
          </p:nvSpPr>
          <p:spPr>
            <a:xfrm>
              <a:off x="2141714" y="1364664"/>
              <a:ext cx="298198" cy="262771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7" name="Rectángulo 16">
              <a:extLst>
                <a:ext uri="{FF2B5EF4-FFF2-40B4-BE49-F238E27FC236}">
                  <a16:creationId xmlns:a16="http://schemas.microsoft.com/office/drawing/2014/main" id="{BFE57910-87AB-557D-67F9-CD4F6840247C}"/>
                </a:ext>
              </a:extLst>
            </p:cNvPr>
            <p:cNvSpPr/>
            <p:nvPr/>
          </p:nvSpPr>
          <p:spPr>
            <a:xfrm>
              <a:off x="5945748" y="1475255"/>
              <a:ext cx="298198" cy="26277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8" name="Rectángulo 17">
              <a:extLst>
                <a:ext uri="{FF2B5EF4-FFF2-40B4-BE49-F238E27FC236}">
                  <a16:creationId xmlns:a16="http://schemas.microsoft.com/office/drawing/2014/main" id="{7F0B5724-1A22-1E2D-0390-D180AFF55900}"/>
                </a:ext>
              </a:extLst>
            </p:cNvPr>
            <p:cNvSpPr/>
            <p:nvPr/>
          </p:nvSpPr>
          <p:spPr>
            <a:xfrm>
              <a:off x="8225682" y="1475255"/>
              <a:ext cx="298198" cy="262771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4FDFA4B4-9601-AFCD-0B07-A3AAEE80EF07}"/>
                </a:ext>
              </a:extLst>
            </p:cNvPr>
            <p:cNvSpPr txBox="1"/>
            <p:nvPr/>
          </p:nvSpPr>
          <p:spPr>
            <a:xfrm>
              <a:off x="6350270" y="1719583"/>
              <a:ext cx="5620273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500" dirty="0"/>
                <a:t>(Soluble </a:t>
              </a:r>
              <a:r>
                <a:rPr lang="es-ES" sz="1500" dirty="0" err="1"/>
                <a:t>Protein</a:t>
              </a:r>
              <a:r>
                <a:rPr lang="es-ES" sz="1500" dirty="0"/>
                <a:t>)                         (</a:t>
              </a:r>
              <a:r>
                <a:rPr lang="es-ES" sz="1500" dirty="0" err="1"/>
                <a:t>Fractions</a:t>
              </a:r>
              <a:r>
                <a:rPr lang="es-ES" sz="1500" dirty="0"/>
                <a:t> </a:t>
              </a:r>
              <a:r>
                <a:rPr lang="es-ES" sz="1500" dirty="0" err="1"/>
                <a:t>with</a:t>
              </a:r>
              <a:r>
                <a:rPr lang="es-ES" sz="1500" dirty="0"/>
                <a:t> </a:t>
              </a:r>
              <a:r>
                <a:rPr lang="es-ES" sz="1500" dirty="0" err="1"/>
                <a:t>Evs</a:t>
              </a:r>
              <a:r>
                <a:rPr lang="es-ES" sz="1500" dirty="0"/>
                <a:t>)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405834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0BA0F8B-D0AE-98F1-9991-BC5DCD069A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CuadroTexto 22">
            <a:extLst>
              <a:ext uri="{FF2B5EF4-FFF2-40B4-BE49-F238E27FC236}">
                <a16:creationId xmlns:a16="http://schemas.microsoft.com/office/drawing/2014/main" id="{4774C3C0-6B04-514C-35D6-2D812D273D1C}"/>
              </a:ext>
            </a:extLst>
          </p:cNvPr>
          <p:cNvSpPr txBox="1"/>
          <p:nvPr/>
        </p:nvSpPr>
        <p:spPr>
          <a:xfrm>
            <a:off x="0" y="32672"/>
            <a:ext cx="229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err="1"/>
              <a:t>Suppl</a:t>
            </a:r>
            <a:r>
              <a:rPr lang="es-ES" b="1"/>
              <a:t>. Fig. 3</a:t>
            </a:r>
          </a:p>
        </p:txBody>
      </p:sp>
      <p:pic>
        <p:nvPicPr>
          <p:cNvPr id="2" name="Imagen 1" descr="Interfaz de usuario gráfica&#10;&#10;El contenido generado por IA puede ser incorrecto.">
            <a:extLst>
              <a:ext uri="{FF2B5EF4-FFF2-40B4-BE49-F238E27FC236}">
                <a16:creationId xmlns:a16="http://schemas.microsoft.com/office/drawing/2014/main" id="{97AECC5F-565A-A340-7B7A-94327763864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905" y="555933"/>
            <a:ext cx="10286865" cy="5746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84010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A1656CA7-C1D2-6834-7526-E1A98FF17136}"/>
              </a:ext>
            </a:extLst>
          </p:cNvPr>
          <p:cNvGrpSpPr/>
          <p:nvPr/>
        </p:nvGrpSpPr>
        <p:grpSpPr>
          <a:xfrm>
            <a:off x="276069" y="553741"/>
            <a:ext cx="11635813" cy="5637701"/>
            <a:chOff x="276069" y="553741"/>
            <a:chExt cx="11635813" cy="5637701"/>
          </a:xfrm>
        </p:grpSpPr>
        <p:pic>
          <p:nvPicPr>
            <p:cNvPr id="5" name="Imagen 4" descr="Gráfico, Gráfico de cajas y bigotes&#10;&#10;Descripción generada automáticamente">
              <a:extLst>
                <a:ext uri="{FF2B5EF4-FFF2-40B4-BE49-F238E27FC236}">
                  <a16:creationId xmlns:a16="http://schemas.microsoft.com/office/drawing/2014/main" id="{6E6B5010-2073-AE23-CF9C-07E601EA1D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6069" y="1161425"/>
              <a:ext cx="5411604" cy="5030017"/>
            </a:xfrm>
            <a:prstGeom prst="rect">
              <a:avLst/>
            </a:prstGeom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6C773CC7-DDF3-7419-0E62-66E90BDB2FFF}"/>
                </a:ext>
              </a:extLst>
            </p:cNvPr>
            <p:cNvSpPr txBox="1"/>
            <p:nvPr/>
          </p:nvSpPr>
          <p:spPr>
            <a:xfrm>
              <a:off x="276069" y="553741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/>
                <a:t>A) CD9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7322E6A7-196F-FE00-4F20-32A66804F72F}"/>
                </a:ext>
              </a:extLst>
            </p:cNvPr>
            <p:cNvSpPr txBox="1"/>
            <p:nvPr/>
          </p:nvSpPr>
          <p:spPr>
            <a:xfrm>
              <a:off x="6374133" y="553741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/>
                <a:t>B) CD81</a:t>
              </a:r>
            </a:p>
          </p:txBody>
        </p:sp>
        <p:pic>
          <p:nvPicPr>
            <p:cNvPr id="9" name="Imagen 8" descr="Gráfico, Gráfico de cajas y bigotes&#10;&#10;Descripción generada automáticamente">
              <a:extLst>
                <a:ext uri="{FF2B5EF4-FFF2-40B4-BE49-F238E27FC236}">
                  <a16:creationId xmlns:a16="http://schemas.microsoft.com/office/drawing/2014/main" id="{48FBFF76-1AB4-B1D2-8338-B113B934E04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4133" y="1076961"/>
              <a:ext cx="5537749" cy="5114481"/>
            </a:xfrm>
            <a:prstGeom prst="rect">
              <a:avLst/>
            </a:prstGeom>
          </p:spPr>
        </p:pic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D4778ABE-4712-3A0F-608A-3D4D7E3809AE}"/>
              </a:ext>
            </a:extLst>
          </p:cNvPr>
          <p:cNvSpPr txBox="1"/>
          <p:nvPr/>
        </p:nvSpPr>
        <p:spPr>
          <a:xfrm>
            <a:off x="0" y="32672"/>
            <a:ext cx="229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err="1"/>
              <a:t>Suppl</a:t>
            </a:r>
            <a:r>
              <a:rPr lang="es-ES" b="1"/>
              <a:t>. Fig. 4</a:t>
            </a:r>
          </a:p>
        </p:txBody>
      </p:sp>
    </p:spTree>
    <p:extLst>
      <p:ext uri="{BB962C8B-B14F-4D97-AF65-F5344CB8AC3E}">
        <p14:creationId xmlns:p14="http://schemas.microsoft.com/office/powerpoint/2010/main" val="26429528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03387EE-724C-8862-E070-9199FFB82C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24F5B5A6-B65C-5C8C-3B07-84D78B2BB286}"/>
              </a:ext>
            </a:extLst>
          </p:cNvPr>
          <p:cNvSpPr txBox="1"/>
          <p:nvPr/>
        </p:nvSpPr>
        <p:spPr>
          <a:xfrm>
            <a:off x="0" y="32672"/>
            <a:ext cx="229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err="1"/>
              <a:t>Suppl</a:t>
            </a:r>
            <a:r>
              <a:rPr lang="es-ES" b="1"/>
              <a:t>. Fig. 5</a:t>
            </a: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E5A325E1-2398-721F-3137-06F5E4FA8E1E}"/>
              </a:ext>
            </a:extLst>
          </p:cNvPr>
          <p:cNvGrpSpPr/>
          <p:nvPr/>
        </p:nvGrpSpPr>
        <p:grpSpPr>
          <a:xfrm>
            <a:off x="410383" y="593961"/>
            <a:ext cx="11656142" cy="5670078"/>
            <a:chOff x="410383" y="593961"/>
            <a:chExt cx="11656142" cy="5670078"/>
          </a:xfrm>
        </p:grpSpPr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E3989D9B-57F3-C13F-F1A8-57D5AED282E1}"/>
                </a:ext>
              </a:extLst>
            </p:cNvPr>
            <p:cNvSpPr txBox="1"/>
            <p:nvPr/>
          </p:nvSpPr>
          <p:spPr>
            <a:xfrm>
              <a:off x="410383" y="593961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/>
                <a:t>A) PIP12</a:t>
              </a:r>
            </a:p>
          </p:txBody>
        </p:sp>
        <p:pic>
          <p:nvPicPr>
            <p:cNvPr id="3" name="Imagen 2" descr="Gráfico, Gráfico de cajas y bigotes&#10;&#10;Descripción generada automáticamente">
              <a:extLst>
                <a:ext uri="{FF2B5EF4-FFF2-40B4-BE49-F238E27FC236}">
                  <a16:creationId xmlns:a16="http://schemas.microsoft.com/office/drawing/2014/main" id="{8AC30B13-4E4C-27EB-6E19-0E1FE853864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383" y="1196739"/>
              <a:ext cx="5981700" cy="5067300"/>
            </a:xfrm>
            <a:prstGeom prst="rect">
              <a:avLst/>
            </a:prstGeom>
          </p:spPr>
        </p:pic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56ACEE0E-E420-088A-EA58-6248017123AB}"/>
                </a:ext>
              </a:extLst>
            </p:cNvPr>
            <p:cNvSpPr txBox="1"/>
            <p:nvPr/>
          </p:nvSpPr>
          <p:spPr>
            <a:xfrm>
              <a:off x="6616996" y="593961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/>
                <a:t>B) CLAH2</a:t>
              </a:r>
            </a:p>
          </p:txBody>
        </p:sp>
        <p:pic>
          <p:nvPicPr>
            <p:cNvPr id="8" name="Imagen 7" descr="Gráfico&#10;&#10;Descripción generada automáticamente con confianza media">
              <a:extLst>
                <a:ext uri="{FF2B5EF4-FFF2-40B4-BE49-F238E27FC236}">
                  <a16:creationId xmlns:a16="http://schemas.microsoft.com/office/drawing/2014/main" id="{CF995791-230A-7D02-75D2-78D3573998B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22925" y="1196739"/>
              <a:ext cx="5943600" cy="50673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214305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CFFDD6-2DD4-8A57-947D-8C173B675F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103C3B7F-91BF-6036-BD1F-564290DED97D}"/>
              </a:ext>
            </a:extLst>
          </p:cNvPr>
          <p:cNvGrpSpPr/>
          <p:nvPr/>
        </p:nvGrpSpPr>
        <p:grpSpPr>
          <a:xfrm>
            <a:off x="267267" y="648048"/>
            <a:ext cx="11772333" cy="5867052"/>
            <a:chOff x="267267" y="648048"/>
            <a:chExt cx="11772333" cy="5867052"/>
          </a:xfrm>
        </p:grpSpPr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E2BA0CE6-AB2D-F6D8-7E52-0112B508837E}"/>
                </a:ext>
              </a:extLst>
            </p:cNvPr>
            <p:cNvSpPr txBox="1"/>
            <p:nvPr/>
          </p:nvSpPr>
          <p:spPr>
            <a:xfrm>
              <a:off x="267267" y="648048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/>
                <a:t>A) SY121</a:t>
              </a:r>
            </a:p>
          </p:txBody>
        </p:sp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32FC2938-3278-BF00-966C-3B9CBBB3F034}"/>
                </a:ext>
              </a:extLst>
            </p:cNvPr>
            <p:cNvSpPr txBox="1"/>
            <p:nvPr/>
          </p:nvSpPr>
          <p:spPr>
            <a:xfrm>
              <a:off x="6096000" y="648048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/>
                <a:t>B) SY132</a:t>
              </a:r>
            </a:p>
          </p:txBody>
        </p:sp>
        <p:pic>
          <p:nvPicPr>
            <p:cNvPr id="8" name="Imagen 7" descr="Gráfico, Gráfico de cajas y bigotes&#10;&#10;Descripción generada automáticamente">
              <a:extLst>
                <a:ext uri="{FF2B5EF4-FFF2-40B4-BE49-F238E27FC236}">
                  <a16:creationId xmlns:a16="http://schemas.microsoft.com/office/drawing/2014/main" id="{1B8C62F8-01BE-5CE5-7C88-631F5AF0E1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1447800"/>
              <a:ext cx="5943600" cy="5067300"/>
            </a:xfrm>
            <a:prstGeom prst="rect">
              <a:avLst/>
            </a:prstGeom>
          </p:spPr>
        </p:pic>
        <p:pic>
          <p:nvPicPr>
            <p:cNvPr id="5" name="Imagen 4" descr="Gráfico, Gráfico de cajas y bigotes&#10;&#10;Descripción generada automáticamente">
              <a:extLst>
                <a:ext uri="{FF2B5EF4-FFF2-40B4-BE49-F238E27FC236}">
                  <a16:creationId xmlns:a16="http://schemas.microsoft.com/office/drawing/2014/main" id="{20B8FDA1-AE6F-F1A0-82E6-64B2BB39A68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267" y="2075537"/>
              <a:ext cx="5240687" cy="4439563"/>
            </a:xfrm>
            <a:prstGeom prst="rect">
              <a:avLst/>
            </a:prstGeom>
          </p:spPr>
        </p:pic>
      </p:grpSp>
      <p:sp>
        <p:nvSpPr>
          <p:cNvPr id="3" name="CuadroTexto 2">
            <a:extLst>
              <a:ext uri="{FF2B5EF4-FFF2-40B4-BE49-F238E27FC236}">
                <a16:creationId xmlns:a16="http://schemas.microsoft.com/office/drawing/2014/main" id="{65172928-AE6B-8C33-79DD-5A9B637A76CD}"/>
              </a:ext>
            </a:extLst>
          </p:cNvPr>
          <p:cNvSpPr txBox="1"/>
          <p:nvPr/>
        </p:nvSpPr>
        <p:spPr>
          <a:xfrm>
            <a:off x="0" y="32672"/>
            <a:ext cx="229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err="1"/>
              <a:t>Suppl</a:t>
            </a:r>
            <a:r>
              <a:rPr lang="es-ES" b="1"/>
              <a:t>. Fig. 6</a:t>
            </a:r>
          </a:p>
        </p:txBody>
      </p:sp>
    </p:spTree>
    <p:extLst>
      <p:ext uri="{BB962C8B-B14F-4D97-AF65-F5344CB8AC3E}">
        <p14:creationId xmlns:p14="http://schemas.microsoft.com/office/powerpoint/2010/main" val="12615939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264D97E-3582-F5B0-CCF9-6F8D6617B35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FA7FEB73-9DD0-4FA8-DD98-ADAE90FB9062}"/>
              </a:ext>
            </a:extLst>
          </p:cNvPr>
          <p:cNvSpPr txBox="1"/>
          <p:nvPr/>
        </p:nvSpPr>
        <p:spPr>
          <a:xfrm>
            <a:off x="0" y="32672"/>
            <a:ext cx="229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err="1"/>
              <a:t>Suppl</a:t>
            </a:r>
            <a:r>
              <a:rPr lang="es-ES" b="1"/>
              <a:t>. Fig. 7</a:t>
            </a: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8720CB10-A890-2038-AAFE-F4FE3EC7E552}"/>
              </a:ext>
            </a:extLst>
          </p:cNvPr>
          <p:cNvGrpSpPr/>
          <p:nvPr/>
        </p:nvGrpSpPr>
        <p:grpSpPr>
          <a:xfrm>
            <a:off x="298450" y="593961"/>
            <a:ext cx="11352776" cy="6047720"/>
            <a:chOff x="298450" y="593961"/>
            <a:chExt cx="11352776" cy="6047720"/>
          </a:xfrm>
        </p:grpSpPr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295CC386-B936-F84F-27D3-48CFA4551327}"/>
                </a:ext>
              </a:extLst>
            </p:cNvPr>
            <p:cNvSpPr txBox="1"/>
            <p:nvPr/>
          </p:nvSpPr>
          <p:spPr>
            <a:xfrm>
              <a:off x="410383" y="593961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 dirty="0"/>
                <a:t>A) CALR1</a:t>
              </a:r>
            </a:p>
          </p:txBody>
        </p:sp>
        <p:pic>
          <p:nvPicPr>
            <p:cNvPr id="10" name="Imagen 9" descr="Diagrama&#10;&#10;El contenido generado por IA puede ser incorrecto.">
              <a:extLst>
                <a:ext uri="{FF2B5EF4-FFF2-40B4-BE49-F238E27FC236}">
                  <a16:creationId xmlns:a16="http://schemas.microsoft.com/office/drawing/2014/main" id="{DBBAB4C8-8AC4-4F4C-85F9-B7D608A105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450" y="1117181"/>
              <a:ext cx="6057900" cy="5524500"/>
            </a:xfrm>
            <a:prstGeom prst="rect">
              <a:avLst/>
            </a:prstGeom>
          </p:spPr>
        </p:pic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C6BE8F4E-992C-7447-2509-E7AF29263320}"/>
                </a:ext>
              </a:extLst>
            </p:cNvPr>
            <p:cNvSpPr txBox="1"/>
            <p:nvPr/>
          </p:nvSpPr>
          <p:spPr>
            <a:xfrm>
              <a:off x="6205497" y="593961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 dirty="0"/>
                <a:t>B) VATA</a:t>
              </a:r>
            </a:p>
          </p:txBody>
        </p:sp>
        <p:pic>
          <p:nvPicPr>
            <p:cNvPr id="4" name="Imagen 3" descr="Gráfico, Gráfico de cajas y bigotes&#10;&#10;Descripción generada automáticamente">
              <a:extLst>
                <a:ext uri="{FF2B5EF4-FFF2-40B4-BE49-F238E27FC236}">
                  <a16:creationId xmlns:a16="http://schemas.microsoft.com/office/drawing/2014/main" id="{279E45B7-4368-7B64-E4C2-3F9C58AE73E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1290271"/>
              <a:ext cx="5555226" cy="470601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731198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DB0761B-59FC-679F-9185-2AB19831BCC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4">
            <a:extLst>
              <a:ext uri="{FF2B5EF4-FFF2-40B4-BE49-F238E27FC236}">
                <a16:creationId xmlns:a16="http://schemas.microsoft.com/office/drawing/2014/main" id="{6497E7FA-28BA-140A-8D77-FBE5446A48A3}"/>
              </a:ext>
            </a:extLst>
          </p:cNvPr>
          <p:cNvGrpSpPr/>
          <p:nvPr/>
        </p:nvGrpSpPr>
        <p:grpSpPr>
          <a:xfrm>
            <a:off x="0" y="593961"/>
            <a:ext cx="12115800" cy="5585859"/>
            <a:chOff x="0" y="593961"/>
            <a:chExt cx="12115800" cy="5585859"/>
          </a:xfrm>
        </p:grpSpPr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68EDEEA1-B6D6-206A-9899-918107620315}"/>
                </a:ext>
              </a:extLst>
            </p:cNvPr>
            <p:cNvSpPr txBox="1"/>
            <p:nvPr/>
          </p:nvSpPr>
          <p:spPr>
            <a:xfrm>
              <a:off x="0" y="593961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/>
                <a:t>A) FLA13</a:t>
              </a:r>
            </a:p>
          </p:txBody>
        </p:sp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6336794C-7391-81CC-BEF1-98EE4CD4FC91}"/>
                </a:ext>
              </a:extLst>
            </p:cNvPr>
            <p:cNvSpPr txBox="1"/>
            <p:nvPr/>
          </p:nvSpPr>
          <p:spPr>
            <a:xfrm>
              <a:off x="6096000" y="593961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/>
                <a:t>B) FLA10</a:t>
              </a:r>
            </a:p>
          </p:txBody>
        </p:sp>
        <p:pic>
          <p:nvPicPr>
            <p:cNvPr id="4" name="Imagen 3" descr="Gráfico&#10;&#10;El contenido generado por IA puede ser incorrecto.">
              <a:extLst>
                <a:ext uri="{FF2B5EF4-FFF2-40B4-BE49-F238E27FC236}">
                  <a16:creationId xmlns:a16="http://schemas.microsoft.com/office/drawing/2014/main" id="{A5B7C925-17FF-F8F5-74CD-8CC9AEC4A2F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200" y="1466850"/>
              <a:ext cx="6019800" cy="4610100"/>
            </a:xfrm>
            <a:prstGeom prst="rect">
              <a:avLst/>
            </a:prstGeom>
          </p:spPr>
        </p:pic>
        <p:pic>
          <p:nvPicPr>
            <p:cNvPr id="7" name="Imagen 6" descr="Diagrama&#10;&#10;El contenido generado por IA puede ser incorrecto.">
              <a:extLst>
                <a:ext uri="{FF2B5EF4-FFF2-40B4-BE49-F238E27FC236}">
                  <a16:creationId xmlns:a16="http://schemas.microsoft.com/office/drawing/2014/main" id="{AEFED427-0F8E-72DE-04BE-C2BE433B124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57900" y="1569720"/>
              <a:ext cx="6057900" cy="4610100"/>
            </a:xfrm>
            <a:prstGeom prst="rect">
              <a:avLst/>
            </a:prstGeom>
          </p:spPr>
        </p:pic>
      </p:grpSp>
      <p:sp>
        <p:nvSpPr>
          <p:cNvPr id="3" name="CuadroTexto 2">
            <a:extLst>
              <a:ext uri="{FF2B5EF4-FFF2-40B4-BE49-F238E27FC236}">
                <a16:creationId xmlns:a16="http://schemas.microsoft.com/office/drawing/2014/main" id="{75B62C02-74EE-05B3-2DDA-79C0A958A2C3}"/>
              </a:ext>
            </a:extLst>
          </p:cNvPr>
          <p:cNvSpPr txBox="1"/>
          <p:nvPr/>
        </p:nvSpPr>
        <p:spPr>
          <a:xfrm>
            <a:off x="0" y="32672"/>
            <a:ext cx="229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/>
              <a:t>Suppl</a:t>
            </a:r>
            <a:r>
              <a:rPr lang="es-ES" b="1" dirty="0"/>
              <a:t>. Fig. 8</a:t>
            </a:r>
          </a:p>
        </p:txBody>
      </p:sp>
    </p:spTree>
    <p:extLst>
      <p:ext uri="{BB962C8B-B14F-4D97-AF65-F5344CB8AC3E}">
        <p14:creationId xmlns:p14="http://schemas.microsoft.com/office/powerpoint/2010/main" val="31796488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26AAE7B-B4CF-D911-3E86-54A7622A7C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CB0FF6ED-ED69-7A7E-BE0E-16DC227BD503}"/>
              </a:ext>
            </a:extLst>
          </p:cNvPr>
          <p:cNvGrpSpPr/>
          <p:nvPr/>
        </p:nvGrpSpPr>
        <p:grpSpPr>
          <a:xfrm>
            <a:off x="3008452" y="852491"/>
            <a:ext cx="6405849" cy="5153017"/>
            <a:chOff x="380999" y="701683"/>
            <a:chExt cx="6405849" cy="5153017"/>
          </a:xfrm>
        </p:grpSpPr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3BDDD9CB-D88C-220E-F3ED-A9D8E7410C8E}"/>
                </a:ext>
              </a:extLst>
            </p:cNvPr>
            <p:cNvSpPr txBox="1"/>
            <p:nvPr/>
          </p:nvSpPr>
          <p:spPr>
            <a:xfrm>
              <a:off x="380999" y="701683"/>
              <a:ext cx="24777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800" b="1"/>
                <a:t>GL33</a:t>
              </a:r>
            </a:p>
          </p:txBody>
        </p:sp>
        <p:pic>
          <p:nvPicPr>
            <p:cNvPr id="3" name="Imagen 2" descr="Diagrama&#10;&#10;Descripción generada automáticamente">
              <a:extLst>
                <a:ext uri="{FF2B5EF4-FFF2-40B4-BE49-F238E27FC236}">
                  <a16:creationId xmlns:a16="http://schemas.microsoft.com/office/drawing/2014/main" id="{B9FDF011-7273-E004-1ECD-46567E0FA0D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1"/>
            <a:stretch>
              <a:fillRect/>
            </a:stretch>
          </p:blipFill>
          <p:spPr>
            <a:xfrm>
              <a:off x="380999" y="1788160"/>
              <a:ext cx="6405849" cy="4066540"/>
            </a:xfrm>
            <a:prstGeom prst="rect">
              <a:avLst/>
            </a:prstGeom>
          </p:spPr>
        </p:pic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B3272DC1-1DDB-8EA1-5FE7-875B821A3BD8}"/>
              </a:ext>
            </a:extLst>
          </p:cNvPr>
          <p:cNvSpPr txBox="1"/>
          <p:nvPr/>
        </p:nvSpPr>
        <p:spPr>
          <a:xfrm>
            <a:off x="196770" y="90545"/>
            <a:ext cx="229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/>
              <a:t>Suppl</a:t>
            </a:r>
            <a:r>
              <a:rPr lang="es-ES" b="1" dirty="0"/>
              <a:t>. Fig. 9</a:t>
            </a:r>
          </a:p>
        </p:txBody>
      </p:sp>
    </p:spTree>
    <p:extLst>
      <p:ext uri="{BB962C8B-B14F-4D97-AF65-F5344CB8AC3E}">
        <p14:creationId xmlns:p14="http://schemas.microsoft.com/office/powerpoint/2010/main" val="11555923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1</TotalTime>
  <Words>540</Words>
  <Application>Microsoft Office PowerPoint</Application>
  <PresentationFormat>Panorámica</PresentationFormat>
  <Paragraphs>67</Paragraphs>
  <Slides>9</Slides>
  <Notes>9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WordVisi_MSFontService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riam Morales Rogriguez de Lope</dc:creator>
  <cp:lastModifiedBy>Miriam Morales Rogriguez de Lope</cp:lastModifiedBy>
  <cp:revision>1</cp:revision>
  <dcterms:created xsi:type="dcterms:W3CDTF">2025-06-16T12:27:27Z</dcterms:created>
  <dcterms:modified xsi:type="dcterms:W3CDTF">2025-08-19T19:24:19Z</dcterms:modified>
</cp:coreProperties>
</file>